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309" r:id="rId2"/>
    <p:sldId id="307" r:id="rId3"/>
    <p:sldId id="312" r:id="rId4"/>
    <p:sldId id="313" r:id="rId5"/>
    <p:sldId id="263" r:id="rId6"/>
    <p:sldId id="311" r:id="rId7"/>
    <p:sldId id="257" r:id="rId8"/>
    <p:sldId id="258" r:id="rId9"/>
    <p:sldId id="260" r:id="rId10"/>
    <p:sldId id="261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74644" autoAdjust="0"/>
  </p:normalViewPr>
  <p:slideViewPr>
    <p:cSldViewPr snapToGrid="0">
      <p:cViewPr>
        <p:scale>
          <a:sx n="90" d="100"/>
          <a:sy n="90" d="100"/>
        </p:scale>
        <p:origin x="-388" y="-5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91EF71-D37A-486B-8EA5-6C752237B8E1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481CA9-26C5-46C1-978F-BBD2C0145A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060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. S1| schematic layout of study desig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EF1923-2C3A-4671-87D3-C98B9BDDDA3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93034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E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481CA9-26C5-46C1-978F-BBD2C0145A5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139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 |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cusCompare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lots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-C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howing the colocalized loci with most significant pleiotropic signals shared in COVID-19 and CAD. Each dot represents a SNP in the region of interest in SAS ancestry. The X-axis represents -log10 P values from the association study of CAD GWAS, and the Y-axis represents the -log10 P values from the association study of COVID-19 GWAS. The lead SNPs are highlighted with a purple square.</a:t>
            </a:r>
            <a:endParaRPr lang="en-US" sz="1200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C61796-9D0F-4F7A-924B-B5C46F7D2C2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4202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B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481CA9-26C5-46C1-978F-BBD2C0145A5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4465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481CA9-26C5-46C1-978F-BBD2C0145A5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08088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00" dirty="0">
                <a:solidFill>
                  <a:srgbClr val="14A07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. S3  |</a:t>
            </a:r>
            <a:r>
              <a:rPr lang="en-US" sz="12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b="0" dirty="0"/>
              <a:t>A review of consequences of consensus signals </a:t>
            </a:r>
            <a:r>
              <a:rPr lang="en-US" sz="1200" b="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y pie char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C61796-9D0F-4F7A-924B-B5C46F7D2C2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66738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00" dirty="0">
                <a:solidFill>
                  <a:srgbClr val="14A075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. S4 |</a:t>
            </a:r>
            <a:r>
              <a:rPr lang="en-US" sz="12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200" b="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airwise LD pattern between colocalized signals in EUR (A-C) and SAS populations (D-F).</a:t>
            </a:r>
            <a:r>
              <a:rPr lang="en-US" sz="12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(A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527095-61A4-4505-94DD-EDFF1A2CF18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31973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B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527095-61A4-4505-94DD-EDFF1A2CF18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99615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C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527095-61A4-4505-94DD-EDFF1A2CF18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58876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527095-61A4-4505-94DD-EDFF1A2CF18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760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1410D-A99D-9B16-4632-2588457CD3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836E22E-5A47-82FA-22AE-21A3E6A7B7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9181F5-0540-EEBA-A419-7105B54C7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3695B-6B15-CB0C-3B42-15AE592AC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DB7C88-C6FA-636D-F0C5-5D7EDC3F8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48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48CCD-9D2B-F64E-2CEA-86F2CB819D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5428A3-E70D-65E6-2A4B-5CB2151FAE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1077B0-2B93-F004-8E82-B99479F3C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E206AF-0341-C2FC-3BFA-D25B4B591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A43A1B-65AF-F7A9-B9E0-8C3DBB364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539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C5B2F5-C9B0-A196-9CA3-62AD4C4BA3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6B9FA1-F0D7-D5E2-A4A1-85F1C0F900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083970-E1AE-856E-58CC-3BAA1AACF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428EC-DE6B-53BF-FEBA-2B9D518BC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4B218-B954-4A0B-213D-BF1332971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98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2E8BB3-A13A-D8FB-288F-D4C081A64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2B3CB6-7FC4-8C66-41A2-A7D549325E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75FF2C-7A0C-7297-8BCE-877177499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E076F4-DC27-1362-4D7D-E96C5B205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D1115F-5A8B-B087-76F8-690EE0FEC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482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5B4F81-1076-2CE5-F302-F1E1B65BC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BF7969-4192-81D9-F232-24ADA12510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962C7-8158-68AD-6E55-F8046E3D3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82241-49A7-96BF-5198-5B307642A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BD2E32-9BDA-DE11-930C-9647EADE6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021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95F042-4488-D6CE-7055-C1E7FA141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E7DE35-FBE0-CA65-A505-6A897ABCB7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D09C95-2717-5BFB-1FB0-33CD6E1280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99494C-0DAB-160D-2D33-2E96DC6BC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F724BE-4561-C98F-376D-32C69B5D5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B4E86C-F2CC-6275-6EDA-5B68D294E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3391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9CB35-1FF7-9A0F-BC2E-20CAA6531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ADA073-6CBB-5397-49EA-2991F6B19B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55D53A-DBD5-C591-B0D2-5B9DD82E9C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24436A-D1C3-3812-D73E-B3620CF8F02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22F2F4-20A6-55A1-7339-BAC2DBA519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0D47954-5502-0E17-71C3-60F3EF2A7E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B36EA1-7430-240D-F87A-2805E5E29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2DE02A-8D44-B9AF-BCDC-958462F3B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967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ABC35-DBB6-C94D-9F8C-509E26B3AA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793D20-515F-830E-A836-CAFBEAB94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DC9B0F-856A-FD77-4F27-A74918AA9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AFB632-B0A5-DC95-2C9D-689701B20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757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56F99B-22D0-19D8-139B-A8A09F2F87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BE285FF-BA79-EE68-6D2C-CF7AB6926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E7447E-CC5A-2458-F62B-6867B07AB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974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6CD2C8-F33F-F5E1-85BD-2C1FE9D82C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E2DB8A-9844-437D-3993-D1A4079119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47B3AE-B2DA-C25D-2F02-24434341B7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8FE4FB-3CFE-8F85-2323-604D8CD31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ADBC55-8533-F7EB-8169-673F8C37F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BB825B-E2B8-8CA5-4745-3D949DDCB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47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63BB87-466C-3F9C-A011-FEF53AB733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5173A7-E905-9ABB-A508-8F300BEEEA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7264E4-A143-3C33-726F-A8EA82E6AD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3B38C3-C919-42A7-25D7-BE8F2C511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E269D9-E65E-BF3B-2CB9-100C7D232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E9F18F-F1A1-D76D-62B5-23BEA4C03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861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A0CA71-30A6-FC54-2704-E22F643865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734422-F028-39F2-5561-8BE55784C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77B443-4FF7-A3A4-9944-B6D751F5B8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536663B-0771-4BAD-8BE0-23D4158A9AC6}" type="datetimeFigureOut">
              <a:rPr lang="en-US" smtClean="0"/>
              <a:t>5/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D3774B-101B-1807-095A-B0371895A6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50E6E-2FBC-75B0-3B9D-DC71020DF2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BAC4A9-8438-44A4-BD04-865FDF1CF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242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54" name="Connector: Curved 153">
            <a:extLst>
              <a:ext uri="{FF2B5EF4-FFF2-40B4-BE49-F238E27FC236}">
                <a16:creationId xmlns:a16="http://schemas.microsoft.com/office/drawing/2014/main" id="{E6D79F36-3CB5-A7A9-6650-50388891085C}"/>
              </a:ext>
            </a:extLst>
          </p:cNvPr>
          <p:cNvCxnSpPr>
            <a:cxnSpLocks/>
            <a:stCxn id="48" idx="6"/>
            <a:endCxn id="46" idx="2"/>
          </p:cNvCxnSpPr>
          <p:nvPr/>
        </p:nvCxnSpPr>
        <p:spPr>
          <a:xfrm>
            <a:off x="6664829" y="4465614"/>
            <a:ext cx="506261" cy="129228"/>
          </a:xfrm>
          <a:prstGeom prst="curvedConnector3">
            <a:avLst>
              <a:gd name="adj1" fmla="val 50000"/>
            </a:avLst>
          </a:prstGeom>
          <a:noFill/>
          <a:ln w="6350" cap="flat" cmpd="sng" algn="ctr">
            <a:solidFill>
              <a:srgbClr val="E97132"/>
            </a:solidFill>
            <a:prstDash val="solid"/>
            <a:miter lim="800000"/>
            <a:tailEnd type="triangle"/>
          </a:ln>
          <a:effectLst/>
        </p:spPr>
      </p:cxnSp>
      <p:grpSp>
        <p:nvGrpSpPr>
          <p:cNvPr id="182" name="Group 181">
            <a:extLst>
              <a:ext uri="{FF2B5EF4-FFF2-40B4-BE49-F238E27FC236}">
                <a16:creationId xmlns:a16="http://schemas.microsoft.com/office/drawing/2014/main" id="{47F30E80-0A58-EBC0-94BF-6837DBB26EBA}"/>
              </a:ext>
            </a:extLst>
          </p:cNvPr>
          <p:cNvGrpSpPr/>
          <p:nvPr/>
        </p:nvGrpSpPr>
        <p:grpSpPr>
          <a:xfrm>
            <a:off x="360510" y="345182"/>
            <a:ext cx="11470980" cy="6167635"/>
            <a:chOff x="237801" y="345182"/>
            <a:chExt cx="11470980" cy="6167635"/>
          </a:xfrm>
        </p:grpSpPr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DCC44194-B34F-F0A2-0F8D-0D6D65426684}"/>
                </a:ext>
              </a:extLst>
            </p:cNvPr>
            <p:cNvGrpSpPr/>
            <p:nvPr/>
          </p:nvGrpSpPr>
          <p:grpSpPr>
            <a:xfrm>
              <a:off x="237801" y="345182"/>
              <a:ext cx="11470980" cy="6167635"/>
              <a:chOff x="182045" y="345182"/>
              <a:chExt cx="11470980" cy="6167635"/>
            </a:xfrm>
          </p:grpSpPr>
          <p:grpSp>
            <p:nvGrpSpPr>
              <p:cNvPr id="153" name="Group 152">
                <a:extLst>
                  <a:ext uri="{FF2B5EF4-FFF2-40B4-BE49-F238E27FC236}">
                    <a16:creationId xmlns:a16="http://schemas.microsoft.com/office/drawing/2014/main" id="{0C5AE2F6-4F8D-7A5B-A469-8040A380DDC4}"/>
                  </a:ext>
                </a:extLst>
              </p:cNvPr>
              <p:cNvGrpSpPr/>
              <p:nvPr/>
            </p:nvGrpSpPr>
            <p:grpSpPr>
              <a:xfrm>
                <a:off x="182045" y="345182"/>
                <a:ext cx="11470980" cy="6167635"/>
                <a:chOff x="193196" y="225548"/>
                <a:chExt cx="11470980" cy="6167635"/>
              </a:xfrm>
            </p:grpSpPr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9827C721-5BA9-24AA-4F2B-5400ABB2F685}"/>
                    </a:ext>
                  </a:extLst>
                </p:cNvPr>
                <p:cNvGrpSpPr/>
                <p:nvPr/>
              </p:nvGrpSpPr>
              <p:grpSpPr>
                <a:xfrm>
                  <a:off x="193196" y="225548"/>
                  <a:ext cx="10760959" cy="6167635"/>
                  <a:chOff x="-92195" y="-721746"/>
                  <a:chExt cx="11725266" cy="7302120"/>
                </a:xfrm>
              </p:grpSpPr>
              <p:grpSp>
                <p:nvGrpSpPr>
                  <p:cNvPr id="88" name="Group 87">
                    <a:extLst>
                      <a:ext uri="{FF2B5EF4-FFF2-40B4-BE49-F238E27FC236}">
                        <a16:creationId xmlns:a16="http://schemas.microsoft.com/office/drawing/2014/main" id="{ADC9B192-9619-4DAB-4BD0-8D932A72A7F1}"/>
                      </a:ext>
                    </a:extLst>
                  </p:cNvPr>
                  <p:cNvGrpSpPr/>
                  <p:nvPr/>
                </p:nvGrpSpPr>
                <p:grpSpPr>
                  <a:xfrm>
                    <a:off x="-92195" y="-721746"/>
                    <a:ext cx="11725266" cy="7302120"/>
                    <a:chOff x="-376671" y="-591118"/>
                    <a:chExt cx="11725266" cy="7302120"/>
                  </a:xfrm>
                </p:grpSpPr>
                <p:grpSp>
                  <p:nvGrpSpPr>
                    <p:cNvPr id="87" name="Group 86">
                      <a:extLst>
                        <a:ext uri="{FF2B5EF4-FFF2-40B4-BE49-F238E27FC236}">
                          <a16:creationId xmlns:a16="http://schemas.microsoft.com/office/drawing/2014/main" id="{5744CB3B-6717-8750-DAFB-81D9FC902AD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376671" y="-591118"/>
                      <a:ext cx="11725266" cy="7302120"/>
                      <a:chOff x="-500764" y="-90377"/>
                      <a:chExt cx="11725266" cy="7302120"/>
                    </a:xfrm>
                  </p:grpSpPr>
                  <p:cxnSp>
                    <p:nvCxnSpPr>
                      <p:cNvPr id="71" name="Connector: Curved 70">
                        <a:extLst>
                          <a:ext uri="{FF2B5EF4-FFF2-40B4-BE49-F238E27FC236}">
                            <a16:creationId xmlns:a16="http://schemas.microsoft.com/office/drawing/2014/main" id="{45EE2BE2-87BE-3585-B633-41C1E8F44B15}"/>
                          </a:ext>
                        </a:extLst>
                      </p:cNvPr>
                      <p:cNvCxnSpPr>
                        <a:cxnSpLocks/>
                        <a:stCxn id="48" idx="4"/>
                        <a:endCxn id="47" idx="0"/>
                      </p:cNvCxnSpPr>
                      <p:nvPr/>
                    </p:nvCxnSpPr>
                    <p:spPr>
                      <a:xfrm rot="5400000">
                        <a:off x="4155354" y="4357840"/>
                        <a:ext cx="266737" cy="1875882"/>
                      </a:xfrm>
                      <a:prstGeom prst="curvedConnector3">
                        <a:avLst>
                          <a:gd name="adj1" fmla="val 50000"/>
                        </a:avLst>
                      </a:prstGeom>
                      <a:noFill/>
                      <a:ln w="6350" cap="flat" cmpd="sng" algn="ctr">
                        <a:solidFill>
                          <a:srgbClr val="E97132"/>
                        </a:solidFill>
                        <a:prstDash val="solid"/>
                        <a:miter lim="800000"/>
                        <a:tailEnd type="triangle"/>
                      </a:ln>
                      <a:effectLst/>
                    </p:spPr>
                  </p:cxnSp>
                  <p:grpSp>
                    <p:nvGrpSpPr>
                      <p:cNvPr id="84" name="Group 83">
                        <a:extLst>
                          <a:ext uri="{FF2B5EF4-FFF2-40B4-BE49-F238E27FC236}">
                            <a16:creationId xmlns:a16="http://schemas.microsoft.com/office/drawing/2014/main" id="{75D45E14-1E68-EFA9-CA84-4AE76195386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500764" y="-90377"/>
                        <a:ext cx="11725266" cy="7302120"/>
                        <a:chOff x="-516000" y="-68605"/>
                        <a:chExt cx="11725266" cy="7302120"/>
                      </a:xfrm>
                    </p:grpSpPr>
                    <p:grpSp>
                      <p:nvGrpSpPr>
                        <p:cNvPr id="83" name="Group 82">
                          <a:extLst>
                            <a:ext uri="{FF2B5EF4-FFF2-40B4-BE49-F238E27FC236}">
                              <a16:creationId xmlns:a16="http://schemas.microsoft.com/office/drawing/2014/main" id="{8A55F359-5AB0-3966-7012-468AA6F6837D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-516000" y="-68605"/>
                          <a:ext cx="11725266" cy="6478596"/>
                          <a:chOff x="-422979" y="-597128"/>
                          <a:chExt cx="11540584" cy="6615613"/>
                        </a:xfrm>
                      </p:grpSpPr>
                      <p:grpSp>
                        <p:nvGrpSpPr>
                          <p:cNvPr id="79" name="Group 78">
                            <a:extLst>
                              <a:ext uri="{FF2B5EF4-FFF2-40B4-BE49-F238E27FC236}">
                                <a16:creationId xmlns:a16="http://schemas.microsoft.com/office/drawing/2014/main" id="{04DB26EA-B244-16E0-BC8D-58368F6507CC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-422979" y="-597128"/>
                            <a:ext cx="11540584" cy="6615613"/>
                            <a:chOff x="-422979" y="-597128"/>
                            <a:chExt cx="11540584" cy="6615613"/>
                          </a:xfrm>
                        </p:grpSpPr>
                        <p:grpSp>
                          <p:nvGrpSpPr>
                            <p:cNvPr id="6" name="Group 5">
                              <a:extLst>
                                <a:ext uri="{FF2B5EF4-FFF2-40B4-BE49-F238E27FC236}">
                                  <a16:creationId xmlns:a16="http://schemas.microsoft.com/office/drawing/2014/main" id="{4EAB81EE-26B5-59C6-BC39-55EF26E5B92F}"/>
                                </a:ext>
                              </a:extLst>
                            </p:cNvPr>
                            <p:cNvGrpSpPr/>
                            <p:nvPr/>
                          </p:nvGrpSpPr>
                          <p:grpSpPr>
                            <a:xfrm>
                              <a:off x="-422979" y="-597128"/>
                              <a:ext cx="11540584" cy="6615613"/>
                              <a:chOff x="-1131618" y="-822300"/>
                              <a:chExt cx="7518211" cy="6042806"/>
                            </a:xfrm>
                          </p:grpSpPr>
                          <p:cxnSp>
                            <p:nvCxnSpPr>
                              <p:cNvPr id="7" name="Connector: Elbow 6">
                                <a:extLst>
                                  <a:ext uri="{FF2B5EF4-FFF2-40B4-BE49-F238E27FC236}">
                                    <a16:creationId xmlns:a16="http://schemas.microsoft.com/office/drawing/2014/main" id="{55E225EB-68D5-09D6-0BC5-9262118391FA}"/>
                                  </a:ext>
                                </a:extLst>
                              </p:cNvPr>
                              <p:cNvCxnSpPr>
                                <a:cxnSpLocks/>
                                <a:stCxn id="46" idx="7"/>
                              </p:cNvCxnSpPr>
                              <p:nvPr/>
                            </p:nvCxnSpPr>
                            <p:spPr>
                              <a:xfrm rot="5400000" flipH="1" flipV="1">
                                <a:off x="4799968" y="3332698"/>
                                <a:ext cx="244997" cy="336915"/>
                              </a:xfrm>
                              <a:prstGeom prst="bentConnector2">
                                <a:avLst/>
                              </a:prstGeom>
                              <a:noFill/>
                              <a:ln w="6350" cap="flat" cmpd="sng" algn="ctr">
                                <a:solidFill>
                                  <a:srgbClr val="156082"/>
                                </a:solidFill>
                                <a:prstDash val="solid"/>
                                <a:miter lim="800000"/>
                                <a:tailEnd type="triangle"/>
                              </a:ln>
                              <a:effectLst/>
                            </p:spPr>
                          </p:cxnSp>
                          <p:grpSp>
                            <p:nvGrpSpPr>
                              <p:cNvPr id="8" name="Group 7">
                                <a:extLst>
                                  <a:ext uri="{FF2B5EF4-FFF2-40B4-BE49-F238E27FC236}">
                                    <a16:creationId xmlns:a16="http://schemas.microsoft.com/office/drawing/2014/main" id="{0D573711-9659-2BFD-1B69-CBC55DF7BBFC}"/>
                                  </a:ext>
                                </a:extLst>
                              </p:cNvPr>
                              <p:cNvGrpSpPr/>
                              <p:nvPr/>
                            </p:nvGrpSpPr>
                            <p:grpSpPr>
                              <a:xfrm>
                                <a:off x="-1131618" y="-822300"/>
                                <a:ext cx="7518211" cy="6042806"/>
                                <a:chOff x="-1131618" y="-835000"/>
                                <a:chExt cx="7518211" cy="6042806"/>
                              </a:xfrm>
                            </p:grpSpPr>
                            <p:grpSp>
                              <p:nvGrpSpPr>
                                <p:cNvPr id="9" name="Group 8">
                                  <a:extLst>
                                    <a:ext uri="{FF2B5EF4-FFF2-40B4-BE49-F238E27FC236}">
                                      <a16:creationId xmlns:a16="http://schemas.microsoft.com/office/drawing/2014/main" id="{B413C54A-4A09-AEB3-4857-CF5AAA4BC9FE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-283249" y="-835000"/>
                                  <a:ext cx="866847" cy="562678"/>
                                  <a:chOff x="-956349" y="-866750"/>
                                  <a:chExt cx="866847" cy="562678"/>
                                </a:xfrm>
                              </p:grpSpPr>
                              <p:sp>
                                <p:nvSpPr>
                                  <p:cNvPr id="56" name="Rectangle: Rounded Corners 55">
                                    <a:extLst>
                                      <a:ext uri="{FF2B5EF4-FFF2-40B4-BE49-F238E27FC236}">
                                        <a16:creationId xmlns:a16="http://schemas.microsoft.com/office/drawing/2014/main" id="{D41865C1-346E-CABD-CE01-B4E957BE174C}"/>
                                      </a:ext>
                                    </a:extLst>
                                  </p:cNvPr>
                                  <p:cNvSpPr/>
                                  <p:nvPr/>
                                </p:nvSpPr>
                                <p:spPr>
                                  <a:xfrm>
                                    <a:off x="-788705" y="-866750"/>
                                    <a:ext cx="699203" cy="484378"/>
                                  </a:xfrm>
                                  <a:prstGeom prst="roundRect">
                                    <a:avLst/>
                                  </a:prstGeom>
                                  <a:noFill/>
                                  <a:ln w="12700" cap="flat" cmpd="sng" algn="ctr">
                                    <a:noFill/>
                                    <a:prstDash val="solid"/>
                                    <a:miter lim="800000"/>
                                  </a:ln>
                                  <a:effectLst/>
                                </p:spPr>
                                <p:txBody>
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<a:prstTxWarp prst="textNoShape">
                                      <a:avLst/>
                                    </a:prstTxWarp>
                                    <a:noAutofit/>
                                  </a:bodyPr>
                                  <a:lstStyle/>
                                  <a:p>
                                    <a:pPr marL="0" marR="0" lvl="0" indent="228600" defTabSz="914400" eaLnBrk="1" fontAlgn="auto" latinLnBrk="0" hangingPunct="1">
                                      <a:spcBef>
                                        <a:spcPts val="0"/>
                                      </a:spcBef>
                                      <a:spcAft>
                                        <a:spcPts val="80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sz="800" b="1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rgbClr val="156082"/>
                                        </a:solidFill>
                                        <a:effectLst/>
                                        <a:uLnTx/>
                                        <a:uFillTx/>
                                        <a:latin typeface="Times New Roman" panose="02020603050405020304" pitchFamily="18" charset="0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rPr>
                                      <a:t>CAD</a:t>
                                    </a:r>
                                    <a:endParaRPr lang="en-US" sz="1200" kern="100" dirty="0">
                                      <a:solidFill>
                                        <a:sysClr val="window" lastClr="FFFFFF"/>
                                      </a:solidFill>
                                      <a:latin typeface="Aptos" panose="02110004020202020204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endParaRPr>
                                  </a:p>
                                  <a:p>
                                    <a:pPr marL="0" marR="0" lvl="0" indent="228600" defTabSz="914400" eaLnBrk="1" fontAlgn="auto" latinLnBrk="0" hangingPunct="1">
                                      <a:spcBef>
                                        <a:spcPts val="0"/>
                                      </a:spcBef>
                                      <a:spcAft>
                                        <a:spcPts val="800"/>
                                      </a:spcAft>
                                      <a:buClrTx/>
                                      <a:buSzTx/>
                                      <a:buFontTx/>
                                      <a:buNone/>
                                      <a:tabLst/>
                                      <a:defRPr/>
                                    </a:pPr>
                                    <a:r>
                                      <a:rPr kumimoji="0" lang="en-US" sz="800" b="1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rgbClr val="156082"/>
                                        </a:solidFill>
                                        <a:effectLst/>
                                        <a:uLnTx/>
                                        <a:uFillTx/>
                                        <a:latin typeface="Times New Roman" panose="02020603050405020304" pitchFamily="18" charset="0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rPr>
                                      <a:t>COVID-19</a:t>
                                    </a:r>
                                    <a:endParaRPr kumimoji="0" lang="en-US" sz="1200" b="0" i="0" u="none" strike="noStrike" kern="100" cap="none" spc="0" normalizeH="0" baseline="0" noProof="0" dirty="0">
                                      <a:ln>
                                        <a:noFill/>
                                      </a:ln>
                                      <a:solidFill>
                                        <a:sysClr val="window" lastClr="FFFFFF"/>
                                      </a:solidFill>
                                      <a:effectLst/>
                                      <a:uLnTx/>
                                      <a:uFillTx/>
                                      <a:latin typeface="Aptos" panose="02110004020202020204"/>
                                      <a:ea typeface="Aptos" panose="020B0004020202020204" pitchFamily="34" charset="0"/>
                                      <a:cs typeface="Times New Roman" panose="02020603050405020304" pitchFamily="18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57" name="Connector: Elbow 56">
                                    <a:extLst>
                                      <a:ext uri="{FF2B5EF4-FFF2-40B4-BE49-F238E27FC236}">
                                        <a16:creationId xmlns:a16="http://schemas.microsoft.com/office/drawing/2014/main" id="{F44DAAD7-B8C7-41DF-0E35-9543D6D39561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  <a:stCxn id="52" idx="7"/>
                                  </p:cNvCxnSpPr>
                                  <p:nvPr/>
                                </p:nvCxnSpPr>
                                <p:spPr>
                                  <a:xfrm rot="5400000" flipH="1" flipV="1">
                                    <a:off x="-979269" y="-663016"/>
                                    <a:ext cx="381864" cy="336023"/>
                                  </a:xfrm>
                                  <a:prstGeom prst="bentConnector2">
                                    <a:avLst/>
                                  </a:prstGeom>
                                  <a:noFill/>
                                  <a:ln w="6350" cap="flat" cmpd="sng" algn="ctr">
                                    <a:solidFill>
                                      <a:srgbClr val="156082"/>
                                    </a:solidFill>
                                    <a:prstDash val="solid"/>
                                    <a:miter lim="800000"/>
                                    <a:tailEnd type="triangle"/>
                                  </a:ln>
                                  <a:effectLst/>
                                </p:spPr>
                              </p:cxnSp>
                            </p:grpSp>
                            <p:grpSp>
                              <p:nvGrpSpPr>
                                <p:cNvPr id="10" name="Group 9">
                                  <a:extLst>
                                    <a:ext uri="{FF2B5EF4-FFF2-40B4-BE49-F238E27FC236}">
                                      <a16:creationId xmlns:a16="http://schemas.microsoft.com/office/drawing/2014/main" id="{837DED76-D27A-BAEC-46AA-D673F47B9C41}"/>
                                    </a:ext>
                                  </a:extLst>
                                </p:cNvPr>
                                <p:cNvGrpSpPr/>
                                <p:nvPr/>
                              </p:nvGrpSpPr>
                              <p:grpSpPr>
                                <a:xfrm>
                                  <a:off x="-1131618" y="-341707"/>
                                  <a:ext cx="7518211" cy="5549513"/>
                                  <a:chOff x="-1131618" y="-856057"/>
                                  <a:chExt cx="7518211" cy="5549513"/>
                                </a:xfrm>
                              </p:grpSpPr>
                              <p:grpSp>
                                <p:nvGrpSpPr>
                                  <p:cNvPr id="11" name="Group 10">
                                    <a:extLst>
                                      <a:ext uri="{FF2B5EF4-FFF2-40B4-BE49-F238E27FC236}">
                                        <a16:creationId xmlns:a16="http://schemas.microsoft.com/office/drawing/2014/main" id="{7433BAAB-4373-986B-3BF6-14F0A2169EE1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5055657" y="1267156"/>
                                    <a:ext cx="1330936" cy="2349541"/>
                                    <a:chOff x="39157" y="-206044"/>
                                    <a:chExt cx="1330936" cy="2349541"/>
                                  </a:xfrm>
                                </p:grpSpPr>
                                <p:sp>
                                  <p:nvSpPr>
                                    <p:cNvPr id="54" name="Rectangle: Rounded Corners 53">
                                      <a:extLst>
                                        <a:ext uri="{FF2B5EF4-FFF2-40B4-BE49-F238E27FC236}">
                                          <a16:creationId xmlns:a16="http://schemas.microsoft.com/office/drawing/2014/main" id="{3E814EE4-5892-591C-E0AB-DA7AA08225B3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39157" y="1671716"/>
                                      <a:ext cx="1330936" cy="471781"/>
                                    </a:xfrm>
                                    <a:prstGeom prst="roundRect">
                                      <a:avLst/>
                                    </a:prstGeom>
                                    <a:noFill/>
                                    <a:ln w="12700" cap="flat" cmpd="sng" algn="ctr">
                                      <a:noFill/>
                                      <a:prstDash val="solid"/>
                                      <a:miter lim="800000"/>
                                    </a:ln>
                                    <a:effectLst/>
                                  </p:spPr>
                                  <p:txBody>
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<a:prstTxWarp prst="textNoShape">
                                        <a:avLst/>
                                      </a:prstTxWarp>
                                      <a:noAutofit/>
                                    </a:bodyPr>
                                    <a:lstStyle/>
                                    <a:p>
                                      <a:pPr marL="0" marR="0" lvl="0" indent="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 Zoom Locus: 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  <a:p>
                                      <a:pPr marL="0" marR="0" lvl="0" indent="45720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LD map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  <a:p>
                                      <a:pPr marL="0" marR="0" lvl="0" indent="45720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%age Recombination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  <a:p>
                                      <a:pPr marL="0" marR="0" lvl="0" indent="45720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Gene Mapping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  <a:p>
                                      <a:pPr marL="0" marR="0" lvl="0" indent="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 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</p:txBody>
                                </p:sp>
                                <p:cxnSp>
                                  <p:nvCxnSpPr>
                                    <p:cNvPr id="55" name="Connector: Elbow 54">
                                      <a:extLst>
                                        <a:ext uri="{FF2B5EF4-FFF2-40B4-BE49-F238E27FC236}">
                                          <a16:creationId xmlns:a16="http://schemas.microsoft.com/office/drawing/2014/main" id="{6360C680-34A5-BA7B-0F77-66D02CA3472E}"/>
                                        </a:ext>
                                      </a:extLst>
                                    </p:cNvPr>
                                    <p:cNvCxnSpPr>
                                      <a:cxnSpLocks/>
                                      <a:stCxn id="45" idx="7"/>
                                    </p:cNvCxnSpPr>
                                    <p:nvPr/>
                                  </p:nvCxnSpPr>
                                  <p:spPr>
                                    <a:xfrm rot="5400000" flipH="1" flipV="1">
                                      <a:off x="819940" y="-230247"/>
                                      <a:ext cx="273311" cy="321717"/>
                                    </a:xfrm>
                                    <a:prstGeom prst="bentConnector2">
                                      <a:avLst/>
                                    </a:prstGeom>
                                    <a:noFill/>
                                    <a:ln w="6350" cap="flat" cmpd="sng" algn="ctr">
                                      <a:solidFill>
                                        <a:srgbClr val="156082"/>
                                      </a:solidFill>
                                      <a:prstDash val="solid"/>
                                      <a:miter lim="800000"/>
                                      <a:tailEnd type="triangle"/>
                                    </a:ln>
                                    <a:effectLst/>
                                  </p:spPr>
                                </p:cxnSp>
                              </p:grpSp>
                              <p:grpSp>
                                <p:nvGrpSpPr>
                                  <p:cNvPr id="18" name="Group 17">
                                    <a:extLst>
                                      <a:ext uri="{FF2B5EF4-FFF2-40B4-BE49-F238E27FC236}">
                                        <a16:creationId xmlns:a16="http://schemas.microsoft.com/office/drawing/2014/main" id="{8C3AFD9A-74CC-E7D9-475E-330869042A43}"/>
                                      </a:ext>
                                    </a:extLst>
                                  </p:cNvPr>
                                  <p:cNvGrpSpPr/>
                                  <p:nvPr/>
                                </p:nvGrpSpPr>
                                <p:grpSpPr>
                                  <a:xfrm>
                                    <a:off x="-1131618" y="-856057"/>
                                    <a:ext cx="7195868" cy="5549513"/>
                                    <a:chOff x="-1131618" y="-856057"/>
                                    <a:chExt cx="7195868" cy="5549513"/>
                                  </a:xfrm>
                                </p:grpSpPr>
                                <p:sp>
                                  <p:nvSpPr>
                                    <p:cNvPr id="19" name="Rectangle: Rounded Corners 18">
                                      <a:extLst>
                                        <a:ext uri="{FF2B5EF4-FFF2-40B4-BE49-F238E27FC236}">
                                          <a16:creationId xmlns:a16="http://schemas.microsoft.com/office/drawing/2014/main" id="{96A8D215-9246-68CD-6F7F-BC42BE565154}"/>
                                        </a:ext>
                                      </a:extLst>
                                    </p:cNvPr>
                                    <p:cNvSpPr/>
                                    <p:nvPr/>
                                  </p:nvSpPr>
                                  <p:spPr>
                                    <a:xfrm>
                                      <a:off x="2805733" y="1184024"/>
                                      <a:ext cx="726847" cy="473678"/>
                                    </a:xfrm>
                                    <a:prstGeom prst="roundRect">
                                      <a:avLst/>
                                    </a:prstGeom>
                                    <a:noFill/>
                                    <a:ln w="12700" cap="flat" cmpd="sng" algn="ctr">
                                      <a:noFill/>
                                      <a:prstDash val="solid"/>
                                      <a:miter lim="800000"/>
                                    </a:ln>
                                    <a:effectLst/>
                                  </p:spPr>
                                  <p:txBody>
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<a:prstTxWarp prst="textNoShape">
                                        <a:avLst/>
                                      </a:prstTxWarp>
                                      <a:noAutofit/>
                                    </a:bodyPr>
                                    <a:lstStyle/>
                                    <a:p>
                                      <a:pPr marL="0" marR="0" lvl="0" indent="22860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Z Score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  <a:p>
                                      <a:pPr marL="0" marR="0" lvl="0" indent="228600" defTabSz="914400" eaLnBrk="1" fontAlgn="auto" latinLnBrk="0" hangingPunct="1">
                                        <a:lnSpc>
                                          <a:spcPct val="115000"/>
                                        </a:lnSpc>
                                        <a:spcBef>
                                          <a:spcPts val="0"/>
                                        </a:spcBef>
                                        <a:spcAft>
                                          <a:spcPts val="800"/>
                                        </a:spcAft>
                                        <a:buClrTx/>
                                        <a:buSzTx/>
                                        <a:buFontTx/>
                                        <a:buNone/>
                                        <a:tabLst/>
                                        <a:defRPr/>
                                      </a:pPr>
                                      <a:r>
                                        <a: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rPr>
                                        <a:t>pval:1e-8</a:t>
                                      </a:r>
                                      <a:endParaRPr kumimoji="0" lang="en-US" sz="1200" b="0" i="0" u="none" strike="noStrike" kern="100" cap="none" spc="0" normalizeH="0" baseline="0" noProof="0" dirty="0">
                                        <a:ln>
                                          <a:noFill/>
                                        </a:ln>
                                        <a:solidFill>
                                          <a:sysClr val="window" lastClr="FFFFFF"/>
                                        </a:solidFill>
                                        <a:effectLst/>
                                        <a:uLnTx/>
                                        <a:uFillTx/>
                                        <a:latin typeface="Aptos" panose="02110004020202020204"/>
                                        <a:ea typeface="Aptos" panose="020B0004020202020204" pitchFamily="34" charset="0"/>
                                        <a:cs typeface="Times New Roman" panose="02020603050405020304" pitchFamily="18" charset="0"/>
                                      </a:endParaRPr>
                                    </a:p>
                                  </p:txBody>
                                </p:sp>
                                <p:cxnSp>
                                  <p:nvCxnSpPr>
                                    <p:cNvPr id="20" name="Connector: Elbow 19">
                                      <a:extLst>
                                        <a:ext uri="{FF2B5EF4-FFF2-40B4-BE49-F238E27FC236}">
                                          <a16:creationId xmlns:a16="http://schemas.microsoft.com/office/drawing/2014/main" id="{1E5711C1-85DE-8518-E5B9-6EA911139576}"/>
                                        </a:ext>
                                      </a:extLst>
                                    </p:cNvPr>
                                    <p:cNvCxnSpPr>
                                      <a:cxnSpLocks/>
                                      <a:stCxn id="51" idx="7"/>
                                    </p:cNvCxnSpPr>
                                    <p:nvPr/>
                                  </p:nvCxnSpPr>
                                  <p:spPr>
                                    <a:xfrm rot="5400000" flipH="1" flipV="1">
                                      <a:off x="2691142" y="1392970"/>
                                      <a:ext cx="274107" cy="281088"/>
                                    </a:xfrm>
                                    <a:prstGeom prst="bentConnector2">
                                      <a:avLst/>
                                    </a:prstGeom>
                                    <a:noFill/>
                                    <a:ln w="6350" cap="flat" cmpd="sng" algn="ctr">
                                      <a:solidFill>
                                        <a:srgbClr val="156082"/>
                                      </a:solidFill>
                                      <a:prstDash val="solid"/>
                                      <a:miter lim="800000"/>
                                      <a:tailEnd type="triangle"/>
                                    </a:ln>
                                    <a:effectLst/>
                                  </p:spPr>
                                </p:cxnSp>
                                <p:grpSp>
                                  <p:nvGrpSpPr>
                                    <p:cNvPr id="22" name="Group 21">
                                      <a:extLst>
                                        <a:ext uri="{FF2B5EF4-FFF2-40B4-BE49-F238E27FC236}">
                                          <a16:creationId xmlns:a16="http://schemas.microsoft.com/office/drawing/2014/main" id="{C6D1DBEF-57C0-7746-3DFF-E062722DEB3E}"/>
                                        </a:ext>
                                      </a:extLst>
                                    </p:cNvPr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-1131618" y="-856057"/>
                                      <a:ext cx="7195868" cy="5549513"/>
                                      <a:chOff x="-1131618" y="-856057"/>
                                      <a:chExt cx="7195868" cy="5549513"/>
                                    </a:xfrm>
                                  </p:grpSpPr>
                                  <p:grpSp>
                                    <p:nvGrpSpPr>
                                      <p:cNvPr id="25" name="Group 24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67390A7-4C29-7D37-F258-7E531F0A4043}"/>
                                          </a:ext>
                                        </a:extLst>
                                      </p:cNvPr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-1131618" y="-856057"/>
                                        <a:ext cx="7195868" cy="5549513"/>
                                        <a:chOff x="-1131618" y="-856057"/>
                                        <a:chExt cx="7195868" cy="5549513"/>
                                      </a:xfrm>
                                    </p:grpSpPr>
                                    <p:grpSp>
                                      <p:nvGrpSpPr>
                                        <p:cNvPr id="28" name="Group 27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277F8092-74B6-4A8F-9D1C-5DAE9D9D046A}"/>
                                            </a:ext>
                                          </a:extLst>
                                        </p:cNvPr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-1131618" y="-856057"/>
                                          <a:ext cx="7195868" cy="5549513"/>
                                          <a:chOff x="-1131618" y="-856057"/>
                                          <a:chExt cx="7195868" cy="5549513"/>
                                        </a:xfrm>
                                      </p:grpSpPr>
                                      <p:grpSp>
                                        <p:nvGrpSpPr>
                                          <p:cNvPr id="30" name="Group 29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E769CB9B-3031-FD12-623E-5D7301859ADF}"/>
                                              </a:ext>
                                            </a:extLst>
                                          </p:cNvPr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-1131618" y="-856057"/>
                                            <a:ext cx="7195868" cy="5549513"/>
                                            <a:chOff x="-1131618" y="-856057"/>
                                            <a:chExt cx="7195868" cy="5549513"/>
                                          </a:xfrm>
                                        </p:grpSpPr>
                                        <p:grpSp>
                                          <p:nvGrpSpPr>
                                            <p:cNvPr id="35" name="Group 34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A5CF598D-B2A1-1B22-973B-F87ACF6D76C5}"/>
                                                </a:ext>
                                              </a:extLst>
                                            </p:cNvPr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-1131618" y="-856057"/>
                                              <a:ext cx="7195868" cy="5549513"/>
                                              <a:chOff x="-1131618" y="-856057"/>
                                              <a:chExt cx="7195868" cy="5549513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37" name="Group 36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44D5F8F4-F435-E2F0-40D3-C57C6BF28772}"/>
                                                  </a:ext>
                                                </a:extLst>
                                              </p:cNvPr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-1131618" y="-856057"/>
                                                <a:ext cx="7195868" cy="5549513"/>
                                                <a:chOff x="-1131618" y="-856057"/>
                                                <a:chExt cx="7195868" cy="5549513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39" name="Group 38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24CAF011-CA40-6DB6-2457-B317BA915BCA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-1131618" y="-856057"/>
                                                  <a:ext cx="2473100" cy="1806217"/>
                                                  <a:chOff x="-1131618" y="-856057"/>
                                                  <a:chExt cx="2473100" cy="1806217"/>
                                                </a:xfrm>
                                              </p:grpSpPr>
                                              <p:sp>
                                                <p:nvSpPr>
                                                  <p:cNvPr id="52" name="Oval 51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5CC3BE90-7D34-43DB-3B99-E24326A392B1}"/>
                                                      </a:ext>
                                                    </a:extLst>
                                                  </p:cNvPr>
                                                  <p:cNvSpPr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-1131618" y="-856057"/>
                                                    <a:ext cx="993927" cy="473773"/>
                                                  </a:xfrm>
                                                  <a:prstGeom prst="ellipse">
                                                    <a:avLst/>
                                                  </a:prstGeom>
                                                  <a:solidFill>
                                                    <a:srgbClr val="E97132"/>
                                                  </a:solidFill>
                                                  <a:ln w="12700" cap="flat" cmpd="sng" algn="ctr">
                                                    <a:noFill/>
                                                    <a:prstDash val="solid"/>
                                                    <a:miter lim="800000"/>
                                                  </a:ln>
                                                  <a:effectLst/>
                                                </p:spPr>
                                                <p:txBody>
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<a:prstTxWarp prst="textNoShape">
                                                      <a:avLst/>
                                                    </a:prstTxWarp>
                                                    <a:noAutofit/>
                                                  </a:bodyPr>
                                                  <a:lstStyle/>
                                                  <a:p>
                                                    <a:pPr marL="0" marR="0" lvl="0" indent="0" algn="ctr" defTabSz="914400" eaLnBrk="1" fontAlgn="auto" latinLnBrk="0" hangingPunct="1">
                                                      <a:lnSpc>
                                                        <a:spcPct val="115000"/>
                                                      </a:lnSpc>
                                                      <a:spcBef>
                                                        <a:spcPts val="0"/>
                                                      </a:spcBef>
                                                      <a:spcAft>
                                                        <a:spcPts val="800"/>
                                                      </a:spcAft>
                                                      <a:buClrTx/>
                                                      <a:buSzTx/>
                                                      <a:buFontTx/>
                                                      <a:buNone/>
                                                      <a:tabLst/>
                                                      <a:defRPr/>
                                                    </a:pPr>
                                                    <a:r>
                                                      <a:rPr kumimoji="0" lang="en-US" sz="1200" b="1" i="0" u="none" strike="noStrike" kern="100" cap="none" spc="0" normalizeH="0" baseline="0" noProof="0" dirty="0">
                                                        <a:ln>
                                                          <a:noFill/>
                                                        </a:ln>
                                                        <a:solidFill>
                                                          <a:sysClr val="window" lastClr="FFFFFF"/>
                                                        </a:solidFill>
                                                        <a:effectLst/>
                                                        <a:uLnTx/>
                                                        <a:uFillTx/>
                                                        <a:latin typeface="Times New Roman" panose="02020603050405020304" pitchFamily="18" charset="0"/>
                                                        <a:ea typeface="Aptos" panose="020B0004020202020204" pitchFamily="34" charset="0"/>
                                                        <a:cs typeface="Times New Roman" panose="02020603050405020304" pitchFamily="18" charset="0"/>
                                                      </a:rPr>
                                                      <a:t>GWAS Summaries</a:t>
                                                    </a:r>
                                                    <a:endParaRPr kumimoji="0" lang="en-US" sz="1200" b="0" i="0" u="none" strike="noStrike" kern="100" cap="none" spc="0" normalizeH="0" baseline="0" noProof="0" dirty="0">
                                                      <a:ln>
                                                        <a:noFill/>
                                                      </a:ln>
                                                      <a:solidFill>
                                                        <a:sysClr val="window" lastClr="FFFFFF"/>
                                                      </a:solidFill>
                                                      <a:effectLst/>
                                                      <a:uLnTx/>
                                                      <a:uFillTx/>
                                                      <a:latin typeface="Aptos" panose="02110004020202020204"/>
                                                      <a:ea typeface="Aptos" panose="020B0004020202020204" pitchFamily="34" charset="0"/>
                                                      <a:cs typeface="Times New Roman" panose="02020603050405020304" pitchFamily="18" charset="0"/>
                                                    </a:endParaRPr>
                                                  </a:p>
                                                </p:txBody>
                                              </p:sp>
                                              <p:sp>
                                                <p:nvSpPr>
                                                  <p:cNvPr id="53" name="Oval 52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4541FC2F-E970-BFEE-29AA-1419CE474C78}"/>
                                                      </a:ext>
                                                    </a:extLst>
                                                  </p:cNvPr>
                                                  <p:cNvSpPr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5592" y="279879"/>
                                                    <a:ext cx="1335890" cy="670281"/>
                                                  </a:xfrm>
                                                  <a:prstGeom prst="ellipse">
                                                    <a:avLst/>
                                                  </a:prstGeom>
                                                  <a:solidFill>
                                                    <a:srgbClr val="E97132"/>
                                                  </a:solidFill>
                                                  <a:ln w="12700" cap="flat" cmpd="sng" algn="ctr">
                                                    <a:noFill/>
                                                    <a:prstDash val="solid"/>
                                                    <a:miter lim="800000"/>
                                                  </a:ln>
                                                  <a:effectLst/>
                                                </p:spPr>
                                                <p:txBody>
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<a:prstTxWarp prst="textNoShape">
                                                      <a:avLst/>
                                                    </a:prstTxWarp>
                                                    <a:noAutofit/>
                                                  </a:bodyPr>
                                                  <a:lstStyle/>
                                                  <a:p>
                                                    <a:pPr marL="0" marR="0" lvl="0" indent="0" algn="ctr" defTabSz="914400" eaLnBrk="1" fontAlgn="auto" latinLnBrk="0" hangingPunct="1">
                                                      <a:lnSpc>
                                                        <a:spcPct val="115000"/>
                                                      </a:lnSpc>
                                                      <a:spcBef>
                                                        <a:spcPts val="0"/>
                                                      </a:spcBef>
                                                      <a:spcAft>
                                                        <a:spcPts val="800"/>
                                                      </a:spcAft>
                                                      <a:buClrTx/>
                                                      <a:buSzTx/>
                                                      <a:buFontTx/>
                                                      <a:buNone/>
                                                      <a:tabLst/>
                                                      <a:defRPr/>
                                                    </a:pPr>
                                                    <a:r>
                                                      <a:rPr lang="en-US" sz="1200" b="1" kern="100" dirty="0">
                                                        <a:solidFill>
                                                          <a:sysClr val="window" lastClr="FFFFFF"/>
                                                        </a:solidFill>
                                                        <a:latin typeface="Times New Roman" panose="02020603050405020304" pitchFamily="18" charset="0"/>
                                                        <a:ea typeface="Aptos" panose="020B0004020202020204" pitchFamily="34" charset="0"/>
                                                        <a:cs typeface="Times New Roman" panose="02020603050405020304" pitchFamily="18" charset="0"/>
                                                      </a:rPr>
                                                      <a:t>Genetic correlation</a:t>
                                                    </a:r>
                                                    <a:endParaRPr kumimoji="0" lang="en-US" sz="1200" b="0" i="0" u="none" strike="noStrike" kern="100" cap="none" spc="0" normalizeH="0" baseline="0" noProof="0" dirty="0">
                                                      <a:ln>
                                                        <a:noFill/>
                                                      </a:ln>
                                                      <a:solidFill>
                                                        <a:sysClr val="window" lastClr="FFFFFF"/>
                                                      </a:solidFill>
                                                      <a:effectLst/>
                                                      <a:uLnTx/>
                                                      <a:uFillTx/>
                                                      <a:latin typeface="Aptos" panose="02110004020202020204"/>
                                                      <a:ea typeface="Aptos" panose="020B0004020202020204" pitchFamily="34" charset="0"/>
                                                      <a:cs typeface="Times New Roman" panose="02020603050405020304" pitchFamily="18" charset="0"/>
                                                    </a:endParaRPr>
                                                  </a:p>
                                                </p:txBody>
                                              </p:sp>
                                            </p:grpSp>
                                            <p:grpSp>
                                              <p:nvGrpSpPr>
                                                <p:cNvPr id="40" name="Group 39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B92E6B90-07E0-58D0-FBA3-B688DAA10674}"/>
                                                    </a:ext>
                                                  </a:extLst>
                                                </p:cNvPr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196296" y="1436314"/>
                                                  <a:ext cx="5867954" cy="3257142"/>
                                                  <a:chOff x="-1048304" y="458414"/>
                                                  <a:chExt cx="5867954" cy="3257142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42" name="Group 41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92C80967-4A67-FCA8-EDB7-714AE644B288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391559" y="590745"/>
                                                    <a:ext cx="2443117" cy="1981459"/>
                                                    <a:chOff x="391559" y="590745"/>
                                                    <a:chExt cx="2443117" cy="1981459"/>
                                                  </a:xfrm>
                                                </p:grpSpPr>
                                                <p:sp>
                                                  <p:nvSpPr>
                                                    <p:cNvPr id="48" name="Oval 47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20D867AC-4D1B-C1AE-EA50-61002A4E006F}"/>
                                                        </a:ext>
                                                      </a:extLst>
                                                    </p:cNvPr>
                                                    <p:cNvSpPr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564047" y="1873704"/>
                                                      <a:ext cx="1464287" cy="698500"/>
                                                    </a:xfrm>
                                                    <a:prstGeom prst="ellipse">
                                                      <a:avLst/>
                                                    </a:prstGeom>
                                                    <a:solidFill>
                                                      <a:srgbClr val="E97132"/>
                                                    </a:solidFill>
                                                    <a:ln w="12700" cap="flat" cmpd="sng" algn="ctr">
                                                      <a:noFill/>
                                                      <a:prstDash val="solid"/>
                                                      <a:miter lim="800000"/>
                                                    </a:ln>
                                                    <a:effectLst/>
                                                  </p:spPr>
                                                  <p:txBody>
  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  <a:prstTxWarp prst="textNoShape">
                                                        <a:avLst/>
                                                      </a:prstTxWarp>
                                                      <a:noAutofit/>
                                                    </a:bodyPr>
                                                    <a:lstStyle/>
                                                    <a:p>
                                                      <a:pPr marL="0" marR="0" lvl="0" indent="0" algn="ctr" defTabSz="914400" eaLnBrk="1" fontAlgn="auto" latinLnBrk="0" hangingPunct="1">
                                                        <a:lnSpc>
                                                          <a:spcPct val="115000"/>
                                                        </a:lnSpc>
                                                        <a:spcBef>
                                                          <a:spcPts val="0"/>
                                                        </a:spcBef>
                                                        <a:spcAft>
                                                          <a:spcPts val="800"/>
                                                        </a:spcAft>
                                                        <a:buClrTx/>
                                                        <a:buSzTx/>
                                                        <a:buFontTx/>
                                                        <a:buNone/>
                                                        <a:tabLst/>
                                                        <a:defRPr/>
                                                      </a:pPr>
                                                      <a:r>
                                                        <a:rPr lang="en-US" sz="1200" b="1" kern="100" dirty="0">
                                                          <a:solidFill>
                                                            <a:sysClr val="window" lastClr="FFFFFF"/>
                                                          </a:solidFill>
                                                          <a:latin typeface="Times New Roman" panose="02020603050405020304" pitchFamily="18" charset="0"/>
                                                          <a:ea typeface="Aptos" panose="020B0004020202020204" pitchFamily="34" charset="0"/>
                                                          <a:cs typeface="Times New Roman" panose="02020603050405020304" pitchFamily="18" charset="0"/>
                                                        </a:rPr>
                                                        <a:t>Gene level analysis</a:t>
                                                      </a:r>
                                                      <a:endParaRPr kumimoji="0" lang="en-US" sz="1200" b="0" i="0" u="none" strike="noStrike" kern="100" cap="none" spc="0" normalizeH="0" baseline="0" noProof="0" dirty="0">
                                                        <a:ln>
                                                          <a:noFill/>
                                                        </a:ln>
                                                        <a:solidFill>
                                                          <a:sysClr val="window" lastClr="FFFFFF"/>
                                                        </a:solidFill>
                                                        <a:effectLst/>
                                                        <a:uLnTx/>
                                                        <a:uFillTx/>
                                                        <a:latin typeface="Aptos" panose="02110004020202020204"/>
                                                        <a:ea typeface="Aptos" panose="020B0004020202020204" pitchFamily="34" charset="0"/>
                                                        <a:cs typeface="Times New Roman" panose="02020603050405020304" pitchFamily="18" charset="0"/>
                                                      </a:endParaRPr>
                                                    </a:p>
                                                  </p:txBody>
                                                </p:sp>
                                                <p:grpSp>
                                                  <p:nvGrpSpPr>
                                                    <p:cNvPr id="49" name="Group 48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245F3B27-C2A6-5A3F-98DF-2C468694913B}"/>
                                                        </a:ext>
                                                      </a:extLst>
                                                    </p:cNvPr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391559" y="590745"/>
                                                      <a:ext cx="2443117" cy="1383411"/>
                                                      <a:chOff x="391559" y="590745"/>
                                                      <a:chExt cx="2443117" cy="1383411"/>
                                                    </a:xfrm>
                                                  </p:grpSpPr>
                                                  <p:sp>
                                                    <p:nvSpPr>
                                                      <p:cNvPr id="51" name="Oval 50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048A0F8F-5512-278B-AE40-2A4B70CD6B6C}"/>
                                                          </a:ext>
                                                        </a:extLst>
                                                      </p:cNvPr>
                                                      <p:cNvSpPr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391559" y="590745"/>
                                                        <a:ext cx="1231900" cy="695964"/>
                                                      </a:xfrm>
                                                      <a:prstGeom prst="ellipse">
                                                        <a:avLst/>
                                                      </a:prstGeom>
                                                      <a:solidFill>
                                                        <a:srgbClr val="E97132"/>
                                                      </a:solidFill>
                                                      <a:ln w="12700" cap="flat" cmpd="sng" algn="ctr">
                                                        <a:noFill/>
                                                        <a:prstDash val="solid"/>
                                                        <a:miter lim="800000"/>
                                                      </a:ln>
                                                      <a:effectLst/>
                                                    </p:spPr>
                                                    <p:txBody>
    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    <a:prstTxWarp prst="textNoShape">
                                                          <a:avLst/>
                                                        </a:prstTxWarp>
                                                        <a:noAutofit/>
                                                      </a:bodyPr>
                                                      <a:lstStyle/>
                                                      <a:p>
                                                        <a:pPr marL="0" marR="0" lvl="0" indent="0" algn="ctr" defTabSz="914400" eaLnBrk="1" fontAlgn="auto" latinLnBrk="0" hangingPunct="1">
                                                          <a:lnSpc>
                                                            <a:spcPct val="115000"/>
                                                          </a:lnSpc>
                                                          <a:spcBef>
                                                            <a:spcPts val="0"/>
                                                          </a:spcBef>
                                                          <a:spcAft>
                                                            <a:spcPts val="800"/>
                                                          </a:spcAft>
                                                          <a:buClrTx/>
                                                          <a:buSzTx/>
                                                          <a:buFontTx/>
                                                          <a:buNone/>
                                                          <a:tabLst/>
                                                          <a:defRPr/>
                                                        </a:pPr>
                                                        <a:r>
                                                          <a:rPr kumimoji="0" lang="en-US" sz="1200" b="1" i="0" u="none" strike="noStrike" kern="100" cap="none" spc="0" normalizeH="0" baseline="0" noProof="0" dirty="0">
                                                            <a:ln>
                                                              <a:noFill/>
                                                            </a:ln>
                                                            <a:solidFill>
                                                              <a:sysClr val="window" lastClr="FFFFFF"/>
                                                            </a:solidFill>
                                                            <a:effectLst/>
                                                            <a:uLnTx/>
                                                            <a:uFillTx/>
                                                            <a:latin typeface="Times New Roman" panose="02020603050405020304" pitchFamily="18" charset="0"/>
                                                            <a:ea typeface="Aptos" panose="020B0004020202020204" pitchFamily="34" charset="0"/>
                                                            <a:cs typeface="Times New Roman" panose="02020603050405020304" pitchFamily="18" charset="0"/>
                                                          </a:rPr>
                                                          <a:t>Effect Estimate</a:t>
                                                        </a:r>
                                                        <a:endParaRPr kumimoji="0" lang="en-US" sz="1200" b="0" i="0" u="none" strike="noStrike" kern="100" cap="none" spc="0" normalizeH="0" baseline="0" noProof="0" dirty="0">
                                                          <a:ln>
                                                            <a:noFill/>
                                                          </a:ln>
                                                          <a:solidFill>
                                                            <a:sysClr val="window" lastClr="FFFFFF"/>
                                                          </a:solidFill>
                                                          <a:effectLst/>
                                                          <a:uLnTx/>
                                                          <a:uFillTx/>
                                                          <a:latin typeface="Aptos" panose="02110004020202020204"/>
                                                          <a:ea typeface="Aptos" panose="020B0004020202020204" pitchFamily="34" charset="0"/>
                                                          <a:cs typeface="Times New Roman" panose="02020603050405020304" pitchFamily="18" charset="0"/>
                                                        </a:endParaRP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82" name="Oval 81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51B97A51-8F67-EAFA-0347-6BDA86DC9A1D}"/>
                                                          </a:ext>
                                                        </a:extLst>
                                                      </p:cNvPr>
                                                      <p:cNvSpPr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1602776" y="857703"/>
                                                        <a:ext cx="1231900" cy="1116453"/>
                                                      </a:xfrm>
                                                      <a:prstGeom prst="ellipse">
                                                        <a:avLst/>
                                                      </a:prstGeom>
                                                      <a:solidFill>
                                                        <a:srgbClr val="E97132"/>
                                                      </a:solidFill>
                                                      <a:ln w="12700" cap="flat" cmpd="sng" algn="ctr">
                                                        <a:noFill/>
                                                        <a:prstDash val="solid"/>
                                                        <a:miter lim="800000"/>
                                                      </a:ln>
                                                      <a:effectLst/>
                                                    </p:spPr>
                                                    <p:txBody>
    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    <a:prstTxWarp prst="textNoShape">
                                                          <a:avLst/>
                                                        </a:prstTxWarp>
                                                        <a:noAutofit/>
                                                      </a:bodyPr>
                                                      <a:lstStyle/>
                                                      <a:p>
                                                        <a:pPr marL="0" marR="0" lvl="0" indent="0" algn="ctr" defTabSz="914400" eaLnBrk="1" fontAlgn="auto" latinLnBrk="0" hangingPunct="1">
                                                          <a:lnSpc>
                                                            <a:spcPct val="115000"/>
                                                          </a:lnSpc>
                                                          <a:spcBef>
                                                            <a:spcPts val="0"/>
                                                          </a:spcBef>
                                                          <a:spcAft>
                                                            <a:spcPts val="800"/>
                                                          </a:spcAft>
                                                          <a:buClrTx/>
                                                          <a:buSzTx/>
                                                          <a:buFontTx/>
                                                          <a:buNone/>
                                                          <a:tabLst/>
                                                          <a:defRPr/>
                                                        </a:pPr>
                                                        <a:r>
                                                          <a:rPr lang="en-US" sz="1200" b="1" kern="100" dirty="0">
                                                            <a:solidFill>
                                                              <a:sysClr val="window" lastClr="FFFFFF"/>
                                                            </a:solidFill>
                                                            <a:latin typeface="Times New Roman" panose="02020603050405020304" pitchFamily="18" charset="0"/>
                                                            <a:ea typeface="Aptos" panose="020B0004020202020204" pitchFamily="34" charset="0"/>
                                                            <a:cs typeface="Times New Roman" panose="02020603050405020304" pitchFamily="18" charset="0"/>
                                                          </a:rPr>
                                                          <a:t>Fine mapping</a:t>
                                                        </a:r>
                                                        <a:endParaRPr kumimoji="0" lang="en-US" sz="1200" b="0" i="0" u="none" strike="noStrike" kern="100" cap="none" spc="0" normalizeH="0" baseline="0" noProof="0" dirty="0">
                                                          <a:ln>
                                                            <a:noFill/>
                                                          </a:ln>
                                                          <a:solidFill>
                                                            <a:sysClr val="window" lastClr="FFFFFF"/>
                                                          </a:solidFill>
                                                          <a:effectLst/>
                                                          <a:uLnTx/>
                                                          <a:uFillTx/>
                                                          <a:latin typeface="Aptos" panose="02110004020202020204"/>
                                                          <a:ea typeface="Aptos" panose="020B0004020202020204" pitchFamily="34" charset="0"/>
                                                          <a:cs typeface="Times New Roman" panose="02020603050405020304" pitchFamily="18" charset="0"/>
                                                        </a:endParaRP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</p:grpSp>
                                              <p:grpSp>
                                                <p:nvGrpSpPr>
                                                  <p:cNvPr id="43" name="Group 42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id="{DF067683-AC1E-BF89-B648-0C7790B835D5}"/>
                                                      </a:ext>
                                                    </a:extLst>
                                                  </p:cNvPr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-1048304" y="458414"/>
                                                    <a:ext cx="5867954" cy="3257142"/>
                                                    <a:chOff x="-2356404" y="-621086"/>
                                                    <a:chExt cx="5867954" cy="3257142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44" name="Group 43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544A0768-B939-A9CF-1038-54F0CD3A731B}"/>
                                                        </a:ext>
                                                      </a:extLst>
                                                    </p:cNvPr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-2356404" y="936910"/>
                                                      <a:ext cx="4751140" cy="1699146"/>
                                                      <a:chOff x="-2356404" y="936910"/>
                                                      <a:chExt cx="4751140" cy="1699146"/>
                                                    </a:xfrm>
                                                  </p:grpSpPr>
                                                  <p:sp>
                                                    <p:nvSpPr>
                                                      <p:cNvPr id="46" name="Oval 45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4513BF20-DA72-5348-6392-9BDE123672A8}"/>
                                                          </a:ext>
                                                        </a:extLst>
                                                      </p:cNvPr>
                                                      <p:cNvSpPr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1073936" y="936910"/>
                                                        <a:ext cx="1320800" cy="698500"/>
                                                      </a:xfrm>
                                                      <a:prstGeom prst="ellipse">
                                                        <a:avLst/>
                                                      </a:prstGeom>
                                                      <a:solidFill>
                                                        <a:srgbClr val="E97132"/>
                                                      </a:solidFill>
                                                      <a:ln w="12700" cap="flat" cmpd="sng" algn="ctr">
                                                        <a:noFill/>
                                                        <a:prstDash val="solid"/>
                                                        <a:miter lim="800000"/>
                                                      </a:ln>
                                                      <a:effectLst/>
                                                    </p:spPr>
                                                    <p:txBody>
    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    <a:prstTxWarp prst="textNoShape">
                                                          <a:avLst/>
                                                        </a:prstTxWarp>
                                                        <a:noAutofit/>
                                                      </a:bodyPr>
                                                      <a:lstStyle/>
                                                      <a:p>
                                                        <a:pPr marL="0" marR="0" lvl="0" indent="0" algn="ctr" defTabSz="914400" eaLnBrk="1" fontAlgn="auto" latinLnBrk="0" hangingPunct="1">
                                                          <a:lnSpc>
                                                            <a:spcPct val="115000"/>
                                                          </a:lnSpc>
                                                          <a:spcBef>
                                                            <a:spcPts val="0"/>
                                                          </a:spcBef>
                                                          <a:spcAft>
                                                            <a:spcPts val="800"/>
                                                          </a:spcAft>
                                                          <a:buClrTx/>
                                                          <a:buSzTx/>
                                                          <a:buFontTx/>
                                                          <a:buNone/>
                                                          <a:tabLst/>
                                                          <a:defRPr/>
                                                        </a:pPr>
                                                        <a:r>
                                                          <a:rPr lang="en-US" sz="1200" b="1" kern="100" dirty="0">
                                                            <a:solidFill>
                                                              <a:sysClr val="window" lastClr="FFFFFF"/>
                                                            </a:solidFill>
                                                            <a:latin typeface="Times New Roman" panose="02020603050405020304" pitchFamily="18" charset="0"/>
                                                            <a:ea typeface="Aptos" panose="020B0004020202020204" pitchFamily="34" charset="0"/>
                                                            <a:cs typeface="Times New Roman" panose="02020603050405020304" pitchFamily="18" charset="0"/>
                                                          </a:rPr>
                                                          <a:t>Visualization</a:t>
                                                        </a:r>
                                                        <a:endParaRPr kumimoji="0" lang="en-US" sz="1200" b="0" i="0" u="none" strike="noStrike" kern="100" cap="none" spc="0" normalizeH="0" baseline="0" noProof="0" dirty="0">
                                                          <a:ln>
                                                            <a:noFill/>
                                                          </a:ln>
                                                          <a:solidFill>
                                                            <a:sysClr val="window" lastClr="FFFFFF"/>
                                                          </a:solidFill>
                                                          <a:effectLst/>
                                                          <a:uLnTx/>
                                                          <a:uFillTx/>
                                                          <a:latin typeface="Aptos" panose="02110004020202020204"/>
                                                          <a:ea typeface="Aptos" panose="020B0004020202020204" pitchFamily="34" charset="0"/>
                                                          <a:cs typeface="Times New Roman" panose="02020603050405020304" pitchFamily="18" charset="0"/>
                                                        </a:endParaRPr>
                                                      </a:p>
                                                    </p:txBody>
                                                  </p:sp>
                                                  <p:sp>
                                                    <p:nvSpPr>
                                                      <p:cNvPr id="47" name="Oval 46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id="{B453242B-B19F-8CBC-AC6D-2638218AEF3B}"/>
                                                          </a:ext>
                                                        </a:extLst>
                                                      </p:cNvPr>
                                                      <p:cNvSpPr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-2356404" y="1741499"/>
                                                        <a:ext cx="2283368" cy="894557"/>
                                                      </a:xfrm>
                                                      <a:prstGeom prst="ellipse">
                                                        <a:avLst/>
                                                      </a:prstGeom>
                                                      <a:solidFill>
                                                        <a:srgbClr val="E97132"/>
                                                      </a:solidFill>
                                                      <a:ln w="12700" cap="flat" cmpd="sng" algn="ctr">
                                                        <a:noFill/>
                                                        <a:prstDash val="solid"/>
                                                        <a:miter lim="800000"/>
                                                      </a:ln>
                                                      <a:effectLst/>
                                                    </p:spPr>
                                                    <p:txBody>
    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    <a:prstTxWarp prst="textNoShape">
                                                          <a:avLst/>
                                                        </a:prstTxWarp>
                                                        <a:noAutofit/>
                                                      </a:bodyPr>
                                                      <a:lstStyle/>
                                                      <a:p>
                                                        <a:pPr marL="0" marR="0" lvl="0" indent="0" algn="ctr" defTabSz="914400" eaLnBrk="1" fontAlgn="auto" latinLnBrk="0" hangingPunct="1">
                                                          <a:lnSpc>
                                                            <a:spcPct val="115000"/>
                                                          </a:lnSpc>
                                                          <a:spcBef>
                                                            <a:spcPts val="0"/>
                                                          </a:spcBef>
                                                          <a:spcAft>
                                                            <a:spcPts val="800"/>
                                                          </a:spcAft>
                                                          <a:buClrTx/>
                                                          <a:buSzTx/>
                                                          <a:buFontTx/>
                                                          <a:buNone/>
                                                          <a:tabLst/>
                                                          <a:defRPr/>
                                                        </a:pPr>
                                                        <a:r>
                                                          <a:rPr lang="en-US" sz="1200" b="1" kern="100" dirty="0">
                                                            <a:solidFill>
                                                              <a:sysClr val="window" lastClr="FFFFFF"/>
                                                            </a:solidFill>
                                                            <a:latin typeface="Times New Roman" panose="02020603050405020304" pitchFamily="18" charset="0"/>
                                                            <a:ea typeface="Aptos" panose="020B0004020202020204" pitchFamily="34" charset="0"/>
                                                            <a:cs typeface="Times New Roman" panose="02020603050405020304" pitchFamily="18" charset="0"/>
                                                          </a:rPr>
                                                          <a:t>Candidate gene v</a:t>
                                                        </a:r>
                                                        <a:r>
                                                          <a:rPr kumimoji="0" lang="en-US" sz="1200" b="1" i="0" u="none" strike="noStrike" kern="100" cap="none" spc="0" normalizeH="0" baseline="0" noProof="0" dirty="0" err="1">
                                                            <a:ln>
                                                              <a:noFill/>
                                                            </a:ln>
                                                            <a:solidFill>
                                                              <a:sysClr val="window" lastClr="FFFFFF"/>
                                                            </a:solidFill>
                                                            <a:effectLst/>
                                                            <a:uLnTx/>
                                                            <a:uFillTx/>
                                                            <a:latin typeface="Times New Roman" panose="02020603050405020304" pitchFamily="18" charset="0"/>
                                                            <a:ea typeface="Aptos" panose="020B0004020202020204" pitchFamily="34" charset="0"/>
                                                            <a:cs typeface="Times New Roman" panose="02020603050405020304" pitchFamily="18" charset="0"/>
                                                          </a:rPr>
                                                          <a:t>alidation</a:t>
                                                        </a:r>
                                                        <a:r>
                                                          <a:rPr kumimoji="0" lang="en-US" sz="1200" b="1" i="0" u="none" strike="noStrike" kern="100" cap="none" spc="0" normalizeH="0" baseline="0" noProof="0" dirty="0">
                                                            <a:ln>
                                                              <a:noFill/>
                                                            </a:ln>
                                                            <a:solidFill>
                                                              <a:sysClr val="window" lastClr="FFFFFF"/>
                                                            </a:solidFill>
                                                            <a:effectLst/>
                                                            <a:uLnTx/>
                                                            <a:uFillTx/>
                                                            <a:latin typeface="Times New Roman" panose="02020603050405020304" pitchFamily="18" charset="0"/>
                                                            <a:ea typeface="Aptos" panose="020B0004020202020204" pitchFamily="34" charset="0"/>
                                                            <a:cs typeface="Times New Roman" panose="02020603050405020304" pitchFamily="18" charset="0"/>
                                                          </a:rPr>
                                                          <a:t> via expression profiling through  RNA-seq</a:t>
                                                        </a:r>
                                                        <a:endParaRPr kumimoji="0" lang="en-US" sz="1200" b="0" i="0" u="none" strike="noStrike" kern="100" cap="none" spc="0" normalizeH="0" baseline="0" noProof="0" dirty="0">
                                                          <a:ln>
                                                            <a:noFill/>
                                                          </a:ln>
                                                          <a:solidFill>
                                                            <a:sysClr val="window" lastClr="FFFFFF"/>
                                                          </a:solidFill>
                                                          <a:effectLst/>
                                                          <a:uLnTx/>
                                                          <a:uFillTx/>
                                                          <a:latin typeface="Aptos" panose="02110004020202020204"/>
                                                          <a:ea typeface="Aptos" panose="020B0004020202020204" pitchFamily="34" charset="0"/>
                                                          <a:cs typeface="Times New Roman" panose="02020603050405020304" pitchFamily="18" charset="0"/>
                                                        </a:endParaRP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  <p:sp>
                                                  <p:nvSpPr>
                                                    <p:cNvPr id="45" name="Oval 44">
                                                      <a:extLst>
                                                        <a:ext uri="{FF2B5EF4-FFF2-40B4-BE49-F238E27FC236}">
                                                          <a16:creationId xmlns:a16="http://schemas.microsoft.com/office/drawing/2014/main" id="{669CE259-EC48-990D-B1FD-1F3F37A7FC49}"/>
                                                        </a:ext>
                                                      </a:extLst>
                                                    </p:cNvPr>
                                                    <p:cNvSpPr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1790700" y="-621086"/>
                                                      <a:ext cx="1720850" cy="711198"/>
                                                    </a:xfrm>
                                                    <a:prstGeom prst="ellipse">
                                                      <a:avLst/>
                                                    </a:prstGeom>
                                                    <a:solidFill>
                                                      <a:srgbClr val="E97132"/>
                                                    </a:solidFill>
                                                    <a:ln w="12700" cap="flat" cmpd="sng" algn="ctr">
                                                      <a:noFill/>
                                                      <a:prstDash val="solid"/>
                                                      <a:miter lim="800000"/>
                                                    </a:ln>
                                                    <a:effectLst/>
                                                  </p:spPr>
                                                  <p:txBody>
              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              <a:prstTxWarp prst="textNoShape">
                                                        <a:avLst/>
                                                      </a:prstTxWarp>
                                                      <a:noAutofit/>
                                                    </a:bodyPr>
                                                    <a:lstStyle/>
                                                    <a:p>
                                                      <a:pPr marL="0" marR="0" lvl="0" indent="0" algn="ctr" defTabSz="914400" eaLnBrk="1" fontAlgn="auto" latinLnBrk="0" hangingPunct="1">
                                                        <a:lnSpc>
                                                          <a:spcPct val="115000"/>
                                                        </a:lnSpc>
                                                        <a:spcBef>
                                                          <a:spcPts val="0"/>
                                                        </a:spcBef>
                                                        <a:spcAft>
                                                          <a:spcPts val="800"/>
                                                        </a:spcAft>
                                                        <a:buClrTx/>
                                                        <a:buSzTx/>
                                                        <a:buFontTx/>
                                                        <a:buNone/>
                                                        <a:tabLst/>
                                                        <a:defRPr/>
                                                      </a:pPr>
                                                      <a:r>
                                                        <a:rPr kumimoji="0" lang="en-US" sz="1200" b="1" i="0" u="none" strike="noStrike" kern="100" cap="none" spc="0" normalizeH="0" baseline="0" noProof="0" dirty="0">
                                                          <a:ln>
                                                            <a:noFill/>
                                                          </a:ln>
                                                          <a:solidFill>
                                                            <a:sysClr val="window" lastClr="FFFFFF"/>
                                                          </a:solidFill>
                                                          <a:effectLst/>
                                                          <a:uLnTx/>
                                                          <a:uFillTx/>
                                                          <a:latin typeface="Times New Roman" panose="02020603050405020304" pitchFamily="18" charset="0"/>
                                                          <a:ea typeface="Aptos" panose="020B0004020202020204" pitchFamily="34" charset="0"/>
                                                          <a:cs typeface="Times New Roman" panose="02020603050405020304" pitchFamily="18" charset="0"/>
                                                        </a:rPr>
                                                        <a:t>Mendelian Randomization</a:t>
                                                      </a:r>
                                                      <a:endParaRPr kumimoji="0" lang="en-US" sz="1200" b="0" i="0" u="none" strike="noStrike" kern="100" cap="none" spc="0" normalizeH="0" baseline="0" noProof="0" dirty="0">
                                                        <a:ln>
                                                          <a:noFill/>
                                                        </a:ln>
                                                        <a:solidFill>
                                                          <a:sysClr val="window" lastClr="FFFFFF"/>
                                                        </a:solidFill>
                                                        <a:effectLst/>
                                                        <a:uLnTx/>
                                                        <a:uFillTx/>
                                                        <a:latin typeface="Aptos" panose="02110004020202020204"/>
                                                        <a:ea typeface="Aptos" panose="020B0004020202020204" pitchFamily="34" charset="0"/>
                                                        <a:cs typeface="Times New Roman" panose="02020603050405020304" pitchFamily="18" charset="0"/>
                                                      </a:endParaRP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</p:grpSp>
                                            <p:cxnSp>
                                              <p:nvCxnSpPr>
                                                <p:cNvPr id="41" name="Connector: Curved 40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id="{1E414E2C-605C-BD2A-3A27-CD82D6CD2FCB}"/>
                                                    </a:ext>
                                                  </a:extLst>
                                                </p:cNvPr>
                                                <p:cNvCxnSpPr>
                                                  <a:cxnSpLocks/>
                                                  <a:stCxn id="53" idx="3"/>
                                                  <a:endCxn id="68" idx="2"/>
                                                </p:cNvCxnSpPr>
                                                <p:nvPr/>
                                              </p:nvCxnSpPr>
                                              <p:spPr>
                                                <a:xfrm rot="16200000" flipH="1">
                                                  <a:off x="119950" y="933278"/>
                                                  <a:ext cx="470682" cy="308126"/>
                                                </a:xfrm>
                                                <a:prstGeom prst="curvedConnector2">
                                                  <a:avLst/>
                                                </a:prstGeom>
                                                <a:noFill/>
                                                <a:ln w="6350" cap="flat" cmpd="sng" algn="ctr">
                                                  <a:solidFill>
                                                    <a:srgbClr val="E97132"/>
                                                  </a:solidFill>
                                                  <a:prstDash val="solid"/>
                                                  <a:miter lim="800000"/>
                                                  <a:tailEnd type="triangle"/>
                                                </a:ln>
                                                <a:effectLst/>
                                              </p:spPr>
                                            </p:cxnSp>
                                          </p:grpSp>
                                          <p:cxnSp>
                                            <p:nvCxnSpPr>
                                              <p:cNvPr id="38" name="Connector: Curved 37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id="{86150877-D119-C4D7-BE3E-6DBBCCC95C5E}"/>
                                                  </a:ext>
                                                </a:extLst>
                                              </p:cNvPr>
                                              <p:cNvCxnSpPr>
                                                <a:cxnSpLocks/>
                                                <a:stCxn id="68" idx="4"/>
                                                <a:endCxn id="51" idx="2"/>
                                              </p:cNvCxnSpPr>
                                              <p:nvPr/>
                                            </p:nvCxnSpPr>
                                            <p:spPr>
                                              <a:xfrm rot="16200000" flipH="1">
                                                <a:off x="1341186" y="1621654"/>
                                                <a:ext cx="188617" cy="401327"/>
                                              </a:xfrm>
                                              <a:prstGeom prst="curvedConnector2">
                                                <a:avLst/>
                                              </a:prstGeom>
                                              <a:noFill/>
                                              <a:ln w="6350" cap="flat" cmpd="sng" algn="ctr">
                                                <a:solidFill>
                                                  <a:srgbClr val="E97132"/>
                                                </a:solidFill>
                                                <a:prstDash val="solid"/>
                                                <a:miter lim="800000"/>
                                                <a:tailEnd type="triangle"/>
                                              </a:ln>
                                              <a:effectLst/>
                                            </p:spPr>
                                          </p:cxnSp>
                                        </p:grpSp>
                                        <p:cxnSp>
                                          <p:nvCxnSpPr>
                                            <p:cNvPr id="34" name="Connector: Curved 33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id="{E6BE49FC-AFB8-8AD7-856B-58EBF4E0EAB5}"/>
                                                </a:ext>
                                              </a:extLst>
                                            </p:cNvPr>
                                            <p:cNvCxnSpPr>
                                              <a:cxnSpLocks/>
                                              <a:stCxn id="51" idx="4"/>
                                              <a:endCxn id="82" idx="2"/>
                                            </p:cNvCxnSpPr>
                                            <p:nvPr/>
                                          </p:nvCxnSpPr>
                                          <p:spPr>
                                            <a:xfrm rot="16200000" flipH="1">
                                              <a:off x="2485131" y="2031584"/>
                                              <a:ext cx="129221" cy="595267"/>
                                            </a:xfrm>
                                            <a:prstGeom prst="curvedConnector2">
                                              <a:avLst/>
                                            </a:prstGeom>
                                            <a:noFill/>
                                            <a:ln w="6350" cap="flat" cmpd="sng" algn="ctr">
                                              <a:solidFill>
                                                <a:srgbClr val="E97132"/>
                                              </a:solidFill>
                                              <a:prstDash val="solid"/>
                                              <a:miter lim="800000"/>
                                              <a:tailEnd type="triangle"/>
                                            </a:ln>
                                            <a:effectLst/>
                                          </p:spPr>
                                        </p:cxnSp>
                                      </p:grpSp>
                                      <p:cxnSp>
                                        <p:nvCxnSpPr>
                                          <p:cNvPr id="31" name="Connector: Curved 3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067681B4-B8F0-03D6-C153-94F102E8C3A2}"/>
                                              </a:ext>
                                            </a:extLst>
                                          </p:cNvPr>
                                          <p:cNvCxnSpPr>
                                            <a:cxnSpLocks/>
                                            <a:stCxn id="82" idx="7"/>
                                            <a:endCxn id="45" idx="3"/>
                                          </p:cNvCxnSpPr>
                                          <p:nvPr/>
                                        </p:nvCxnSpPr>
                                        <p:spPr>
                                          <a:xfrm rot="16200000" flipH="1">
                                            <a:off x="4225011" y="1672959"/>
                                            <a:ext cx="44257" cy="696544"/>
                                          </a:xfrm>
                                          <a:prstGeom prst="curvedConnector5">
                                            <a:avLst>
                                              <a:gd name="adj1" fmla="val -570402"/>
                                              <a:gd name="adj2" fmla="val 44860"/>
                                              <a:gd name="adj3" fmla="val 670402"/>
                                            </a:avLst>
                                          </a:prstGeom>
                                          <a:noFill/>
                                          <a:ln w="6350" cap="flat" cmpd="sng" algn="ctr">
                                            <a:solidFill>
                                              <a:srgbClr val="E97132"/>
                                            </a:solidFill>
                                            <a:prstDash val="solid"/>
                                            <a:miter lim="800000"/>
                                            <a:tailEnd type="triangle"/>
                                          </a:ln>
                                          <a:effectLst/>
                                        </p:spPr>
                                      </p:cxnSp>
                                      <p:cxnSp>
                                        <p:nvCxnSpPr>
                                          <p:cNvPr id="32" name="Connector: Curved 3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id="{FD74AC44-5C7F-FA6F-E1AE-EF5AE15AEE38}"/>
                                              </a:ext>
                                            </a:extLst>
                                          </p:cNvPr>
                                          <p:cNvCxnSpPr>
                                            <a:cxnSpLocks/>
                                            <a:stCxn id="52" idx="4"/>
                                            <a:endCxn id="65" idx="2"/>
                                          </p:cNvCxnSpPr>
                                          <p:nvPr/>
                                        </p:nvCxnSpPr>
                                        <p:spPr>
                                          <a:xfrm rot="16200000" flipH="1">
                                            <a:off x="-712341" y="-304598"/>
                                            <a:ext cx="288544" cy="133170"/>
                                          </a:xfrm>
                                          <a:prstGeom prst="curvedConnector2">
                                            <a:avLst/>
                                          </a:prstGeom>
                                          <a:noFill/>
                                          <a:ln w="6350" cap="flat" cmpd="sng" algn="ctr">
                                            <a:solidFill>
                                              <a:srgbClr val="E97132"/>
                                            </a:solidFill>
                                            <a:prstDash val="solid"/>
                                            <a:miter lim="800000"/>
                                            <a:tailEnd type="triangle"/>
                                          </a:ln>
                                          <a:effectLst/>
                                        </p:spPr>
                                      </p:cxnSp>
                                    </p:grpSp>
                                    <p:cxnSp>
                                      <p:nvCxnSpPr>
                                        <p:cNvPr id="29" name="Connector: Curved 28">
                                          <a:extLst>
                                            <a:ext uri="{FF2B5EF4-FFF2-40B4-BE49-F238E27FC236}">
                                              <a16:creationId xmlns:a16="http://schemas.microsoft.com/office/drawing/2014/main" id="{059DAF9E-5F68-E1CD-503E-86C2A3650F0C}"/>
                                            </a:ext>
                                          </a:extLst>
                                        </p:cNvPr>
                                        <p:cNvCxnSpPr>
                                          <a:cxnSpLocks/>
                                          <a:stCxn id="82" idx="4"/>
                                          <a:endCxn id="48" idx="0"/>
                                        </p:cNvCxnSpPr>
                                        <p:nvPr/>
                                      </p:nvCxnSpPr>
                                      <p:spPr>
                                        <a:xfrm rot="5400000" flipH="1">
                                          <a:off x="2951832" y="2440562"/>
                                          <a:ext cx="100452" cy="922536"/>
                                        </a:xfrm>
                                        <a:prstGeom prst="curvedConnector5">
                                          <a:avLst>
                                            <a:gd name="adj1" fmla="val 190011"/>
                                            <a:gd name="adj2" fmla="val 69153"/>
                                            <a:gd name="adj3" fmla="val 351308"/>
                                          </a:avLst>
                                        </a:prstGeom>
                                        <a:noFill/>
                                        <a:ln w="6350" cap="flat" cmpd="sng" algn="ctr">
                                          <a:solidFill>
                                            <a:srgbClr val="E97132"/>
                                          </a:solidFill>
                                          <a:prstDash val="solid"/>
                                          <a:miter lim="800000"/>
                                          <a:tailEnd type="triangle"/>
                                        </a:ln>
                                        <a:effectLst/>
                                      </p:spPr>
                                    </p:cxnSp>
                                  </p:grpSp>
                                  <p:sp>
                                    <p:nvSpPr>
                                      <p:cNvPr id="26" name="Rectangle: Rounded Corners 25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9115B680-31B2-E3C2-484B-3D8F0931554B}"/>
                                          </a:ext>
                                        </a:extLst>
                                      </p:cNvPr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1787501" y="466300"/>
                                        <a:ext cx="1072185" cy="641350"/>
                                      </a:xfrm>
                                      <a:prstGeom prst="roundRect">
                                        <a:avLst/>
                                      </a:prstGeom>
                                      <a:noFill/>
                                      <a:ln w="12700" cap="flat" cmpd="sng" algn="ctr">
                                        <a:noFill/>
                                        <a:prstDash val="solid"/>
                                        <a:miter lim="800000"/>
                                      </a:ln>
                                      <a:effectLst/>
                                    </p:spPr>
                                    <p:txBody>
          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          <a:prstTxWarp prst="textNoShape">
                                          <a:avLst/>
                                        </a:prstTxWarp>
                                        <a:noAutofit/>
                                      </a:bodyPr>
                                      <a:lstStyle/>
                                      <a:p>
                                        <a:pPr marL="0" marR="0" lvl="0" indent="228600" defTabSz="914400" eaLnBrk="1" fontAlgn="auto" latinLnBrk="0" hangingPunct="1">
                                          <a:spcBef>
                                            <a:spcPts val="0"/>
                                          </a:spcBef>
                                          <a:spcAft>
                                            <a:spcPts val="800"/>
                                          </a:spcAft>
                                          <a:buClrTx/>
                                          <a:buSzTx/>
                                          <a:buFontTx/>
                                          <a:buNone/>
                                          <a:tabLst/>
                                          <a:defRPr/>
                                        </a:pPr>
                                        <a:r>
                                          <a:rPr kumimoji="0" lang="en-US" sz="800" b="1" i="0" u="none" strike="noStrike" kern="100" cap="none" spc="0" normalizeH="0" baseline="0" noProof="0" dirty="0" err="1">
                                            <a:ln>
                                              <a:noFill/>
                                            </a:ln>
                                            <a:solidFill>
                                              <a:srgbClr val="156082"/>
                                            </a:solidFill>
                                            <a:effectLst/>
                                            <a:uLnTx/>
                                            <a:uFillTx/>
                                            <a:latin typeface="Times New Roman" panose="02020603050405020304" pitchFamily="18" charset="0"/>
                                            <a:ea typeface="Aptos" panose="020B0004020202020204" pitchFamily="34" charset="0"/>
                                            <a:cs typeface="Times New Roman" panose="02020603050405020304" pitchFamily="18" charset="0"/>
                                          </a:rPr>
                                          <a:t>Coloc.abf</a:t>
                                        </a:r>
                                        <a:endParaRPr kumimoji="0" lang="en-US" sz="1200" b="0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ysClr val="window" lastClr="FFFFFF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Aptos" panose="02110004020202020204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endParaRPr>
                                      </a:p>
                                      <a:p>
                                        <a:pPr marL="0" marR="0" lvl="0" indent="228600" defTabSz="914400" eaLnBrk="1" fontAlgn="auto" latinLnBrk="0" hangingPunct="1">
                                          <a:spcBef>
                                            <a:spcPts val="0"/>
                                          </a:spcBef>
                                          <a:spcAft>
                                            <a:spcPts val="800"/>
                                          </a:spcAft>
                                          <a:buClrTx/>
                                          <a:buSzTx/>
                                          <a:buFontTx/>
                                          <a:buNone/>
                                          <a:tabLst/>
                                          <a:defRPr/>
                                        </a:pPr>
                                        <a:r>
                                          <a:rPr kumimoji="0" lang="en-US" sz="800" b="1" i="0" u="none" strike="noStrike" kern="100" cap="none" spc="0" normalizeH="0" baseline="0" noProof="0" dirty="0" err="1">
                                            <a:ln>
                                              <a:noFill/>
                                            </a:ln>
                                            <a:solidFill>
                                              <a:srgbClr val="156082"/>
                                            </a:solidFill>
                                            <a:effectLst/>
                                            <a:uLnTx/>
                                            <a:uFillTx/>
                                            <a:latin typeface="Times New Roman" panose="02020603050405020304" pitchFamily="18" charset="0"/>
                                            <a:ea typeface="Aptos" panose="020B0004020202020204" pitchFamily="34" charset="0"/>
                                            <a:cs typeface="Times New Roman" panose="02020603050405020304" pitchFamily="18" charset="0"/>
                                          </a:rPr>
                                          <a:t>Hyprcoloc</a:t>
                                        </a:r>
                                        <a:endParaRPr kumimoji="0" lang="en-US" sz="800" b="1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rgbClr val="156082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Times New Roman" panose="02020603050405020304" pitchFamily="18" charset="0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endParaRPr>
                                      </a:p>
                                      <a:p>
                                        <a:pPr lvl="0" indent="228600">
                                          <a:spcAft>
                                            <a:spcPts val="800"/>
                                          </a:spcAft>
                                          <a:defRPr/>
                                        </a:pPr>
                                        <a:r>
                                          <a:rPr lang="en-US" sz="900" b="1" kern="100" dirty="0" err="1">
                                            <a:solidFill>
                                              <a:srgbClr val="156082"/>
                                            </a:solidFill>
                                            <a:latin typeface="Times New Roman" panose="02020603050405020304" pitchFamily="18" charset="0"/>
                                            <a:ea typeface="Aptos" panose="020B0004020202020204" pitchFamily="34" charset="0"/>
                                            <a:cs typeface="Times New Roman" panose="02020603050405020304" pitchFamily="18" charset="0"/>
                                          </a:rPr>
                                          <a:t>LocusCompareR</a:t>
                                        </a:r>
                                        <a:endParaRPr kumimoji="0" lang="en-US" sz="900" b="0" i="0" u="none" strike="noStrike" kern="100" cap="none" spc="0" normalizeH="0" baseline="0" noProof="0" dirty="0">
                                          <a:ln>
                                            <a:noFill/>
                                          </a:ln>
                                          <a:solidFill>
                                            <a:sysClr val="window" lastClr="FFFFFF"/>
                                          </a:solidFill>
                                          <a:effectLst/>
                                          <a:uLnTx/>
                                          <a:uFillTx/>
                                          <a:latin typeface="Aptos" panose="02110004020202020204"/>
                                          <a:ea typeface="Aptos" panose="020B0004020202020204" pitchFamily="34" charset="0"/>
                                          <a:cs typeface="Times New Roman" panose="02020603050405020304" pitchFamily="18" charset="0"/>
                                        </a:endParaRPr>
                                      </a:p>
                                    </p:txBody>
                                  </p:sp>
                                  <p:cxnSp>
                                    <p:nvCxnSpPr>
                                      <p:cNvPr id="27" name="Connector: Elbow 26">
                                        <a:extLst>
                                          <a:ext uri="{FF2B5EF4-FFF2-40B4-BE49-F238E27FC236}">
                                            <a16:creationId xmlns:a16="http://schemas.microsoft.com/office/drawing/2014/main" id="{239BDE77-7E17-8BCA-18E4-A611564EE9C2}"/>
                                          </a:ext>
                                        </a:extLst>
                                      </p:cNvPr>
                                      <p:cNvCxnSpPr>
                                        <a:cxnSpLocks/>
                                        <a:stCxn id="53" idx="7"/>
                                      </p:cNvCxnSpPr>
                                      <p:nvPr/>
                                    </p:nvCxnSpPr>
                                    <p:spPr>
                                      <a:xfrm rot="5400000" flipH="1" flipV="1">
                                        <a:off x="1098173" y="138327"/>
                                        <a:ext cx="287386" cy="192040"/>
                                      </a:xfrm>
                                      <a:prstGeom prst="bentConnector2">
                                        <a:avLst/>
                                      </a:prstGeom>
                                      <a:noFill/>
                                      <a:ln w="6350" cap="flat" cmpd="sng" algn="ctr">
                                        <a:solidFill>
                                          <a:sysClr val="windowText" lastClr="000000"/>
                                        </a:solidFill>
                                        <a:prstDash val="solid"/>
                                        <a:miter lim="800000"/>
                                        <a:tailEnd type="triangle"/>
                                      </a:ln>
                                      <a:effectLst/>
                                    </p:spPr>
                                  </p:cxnSp>
                                </p:grpSp>
                              </p:grpSp>
                            </p:grpSp>
                          </p:grpSp>
                        </p:grpSp>
                        <p:sp>
                          <p:nvSpPr>
                            <p:cNvPr id="65" name="Oval 64">
                              <a:extLst>
                                <a:ext uri="{FF2B5EF4-FFF2-40B4-BE49-F238E27FC236}">
                                  <a16:creationId xmlns:a16="http://schemas.microsoft.com/office/drawing/2014/main" id="{BCEBC5F0-FC65-230B-8AD9-51A1192414C3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544288" y="332117"/>
                              <a:ext cx="2102398" cy="890775"/>
                            </a:xfrm>
                            <a:prstGeom prst="ellipse">
                              <a:avLst/>
                            </a:prstGeom>
                            <a:solidFill>
                              <a:srgbClr val="E97132"/>
                            </a:solidFill>
                            <a:ln w="12700" cap="flat" cmpd="sng" algn="ctr">
                              <a:noFill/>
                              <a:prstDash val="solid"/>
                              <a:miter lim="800000"/>
                            </a:ln>
                            <a:effectLst/>
                          </p:spPr>
                          <p:txBody>
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<a:prstTxWarp prst="textNoShape">
                                <a:avLst/>
                              </a:prstTxWarp>
                              <a:noAutofit/>
                            </a:bodyPr>
                            <a:lstStyle/>
                            <a:p>
                              <a:pPr marL="0" marR="0" lvl="0" indent="0" algn="ctr" defTabSz="914400" eaLnBrk="1" fontAlgn="auto" latinLnBrk="0" hangingPunct="1">
                                <a:lnSpc>
                                  <a:spcPct val="115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80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kumimoji="0" lang="en-US" sz="1200" b="1" i="0" u="none" strike="noStrike" kern="1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sysClr val="window" lastClr="FFFFFF"/>
                                  </a:solidFill>
                                  <a:effectLst/>
                                  <a:uLnTx/>
                                  <a:uFillTx/>
                                  <a:latin typeface="Times New Roman" panose="020206030504050203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a:t>Genetic quality control &amp; risk loci</a:t>
                              </a:r>
                              <a:endParaRPr kumimoji="0" lang="en-US" sz="1200" b="0" i="0" u="none" strike="noStrike" kern="1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sysClr val="window" lastClr="FFFFFF"/>
                                </a:solidFill>
                                <a:effectLst/>
                                <a:uLnTx/>
                                <a:uFillTx/>
                                <a:latin typeface="Aptos" panose="02110004020202020204"/>
                                <a:ea typeface="Aptos" panose="020B0004020202020204" pitchFamily="34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  <p:grpSp>
                        <p:nvGrpSpPr>
                          <p:cNvPr id="70" name="Group 69">
                            <a:extLst>
                              <a:ext uri="{FF2B5EF4-FFF2-40B4-BE49-F238E27FC236}">
                                <a16:creationId xmlns:a16="http://schemas.microsoft.com/office/drawing/2014/main" id="{E2C2420E-8979-0E29-D24A-E3C554AAA486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095942" y="1730448"/>
                            <a:ext cx="2268780" cy="1041491"/>
                            <a:chOff x="2020967" y="6109736"/>
                            <a:chExt cx="2816070" cy="1979958"/>
                          </a:xfrm>
                        </p:grpSpPr>
                        <p:cxnSp>
                          <p:nvCxnSpPr>
                            <p:cNvPr id="67" name="Connector: Elbow 66">
                              <a:extLst>
                                <a:ext uri="{FF2B5EF4-FFF2-40B4-BE49-F238E27FC236}">
                                  <a16:creationId xmlns:a16="http://schemas.microsoft.com/office/drawing/2014/main" id="{540E64EF-DFCE-BF52-5FA1-7B89FA4ABC79}"/>
                                </a:ext>
                              </a:extLst>
                            </p:cNvPr>
                            <p:cNvCxnSpPr>
                              <a:cxnSpLocks/>
                              <a:stCxn id="68" idx="7"/>
                            </p:cNvCxnSpPr>
                            <p:nvPr/>
                          </p:nvCxnSpPr>
                          <p:spPr>
                            <a:xfrm rot="5400000" flipH="1" flipV="1">
                              <a:off x="4338913" y="6151448"/>
                              <a:ext cx="539836" cy="456412"/>
                            </a:xfrm>
                            <a:prstGeom prst="bentConnector2">
                              <a:avLst/>
                            </a:prstGeom>
                            <a:noFill/>
                            <a:ln w="6350" cap="flat" cmpd="sng" algn="ctr">
                              <a:solidFill>
                                <a:srgbClr val="156082"/>
                              </a:solidFill>
                              <a:prstDash val="solid"/>
                              <a:miter lim="800000"/>
                              <a:tailEnd type="triangle"/>
                            </a:ln>
                            <a:effectLst/>
                          </p:spPr>
                        </p:cxnSp>
                        <p:sp>
                          <p:nvSpPr>
                            <p:cNvPr id="68" name="Oval 67">
                              <a:extLst>
                                <a:ext uri="{FF2B5EF4-FFF2-40B4-BE49-F238E27FC236}">
                                  <a16:creationId xmlns:a16="http://schemas.microsoft.com/office/drawing/2014/main" id="{8B214D90-71C6-61A6-A10F-1D70415291FD}"/>
                                </a:ext>
                              </a:extLst>
                            </p:cNvPr>
                            <p:cNvSpPr/>
                            <p:nvPr/>
                          </p:nvSpPr>
                          <p:spPr>
                            <a:xfrm>
                              <a:off x="2020967" y="6402486"/>
                              <a:ext cx="2764510" cy="1687208"/>
                            </a:xfrm>
                            <a:prstGeom prst="ellipse">
                              <a:avLst/>
                            </a:prstGeom>
                            <a:solidFill>
                              <a:srgbClr val="E97132"/>
                            </a:solidFill>
                            <a:ln w="12700" cap="flat" cmpd="sng" algn="ctr">
                              <a:noFill/>
                              <a:prstDash val="solid"/>
                              <a:miter lim="800000"/>
                            </a:ln>
                            <a:effectLst/>
                          </p:spPr>
                          <p:txBody>
                            <a:bodyPr rot="0" spcFirstLastPara="0" vert="horz" wrap="square" lIns="91440" tIns="45720" rIns="91440" bIns="45720" numCol="1" spcCol="0" rtlCol="0" fromWordArt="0" anchor="ctr" anchorCtr="0" forceAA="0" compatLnSpc="1">
                              <a:prstTxWarp prst="textNoShape">
                                <a:avLst/>
                              </a:prstTxWarp>
                              <a:noAutofit/>
                            </a:bodyPr>
                            <a:lstStyle/>
                            <a:p>
                              <a:pPr algn="ctr">
                                <a:lnSpc>
                                  <a:spcPct val="115000"/>
                                </a:lnSpc>
                                <a:spcAft>
                                  <a:spcPts val="800"/>
                                </a:spcAft>
                                <a:defRPr/>
                              </a:pPr>
                              <a:endParaRPr kumimoji="0" lang="en-US" sz="1200" b="1" i="0" u="none" strike="noStrike" kern="1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sysClr val="window" lastClr="FFFFFF"/>
                                </a:solidFill>
                                <a:effectLst/>
                                <a:uLnTx/>
                                <a:uFillTx/>
                                <a:latin typeface="Times New Roman" panose="02020603050405020304" pitchFamily="18" charset="0"/>
                                <a:ea typeface="Aptos" panose="020B0004020202020204" pitchFamily="34" charset="0"/>
                                <a:cs typeface="Times New Roman" panose="02020603050405020304" pitchFamily="18" charset="0"/>
                              </a:endParaRPr>
                            </a:p>
                            <a:p>
                              <a:pPr algn="ctr">
                                <a:lnSpc>
                                  <a:spcPct val="115000"/>
                                </a:lnSpc>
                                <a:spcAft>
                                  <a:spcPts val="800"/>
                                </a:spcAft>
                                <a:defRPr/>
                              </a:pPr>
                              <a:r>
                                <a:rPr kumimoji="0" lang="en-US" sz="1200" b="1" i="0" u="none" strike="noStrike" kern="100" cap="none" spc="0" normalizeH="0" baseline="0" noProof="0" dirty="0">
                                  <a:ln>
                                    <a:noFill/>
                                  </a:ln>
                                  <a:solidFill>
                                    <a:sysClr val="window" lastClr="FFFFFF"/>
                                  </a:solidFill>
                                  <a:effectLst/>
                                  <a:uLnTx/>
                                  <a:uFillTx/>
                                  <a:latin typeface="Times New Roman" panose="020206030504050203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a:t>Colocalization</a:t>
                              </a:r>
                              <a:endParaRPr kumimoji="0" lang="en-US" sz="1200" b="0" i="0" u="none" strike="noStrike" kern="1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sysClr val="window" lastClr="FFFFFF"/>
                                </a:solidFill>
                                <a:effectLst/>
                                <a:uLnTx/>
                                <a:uFillTx/>
                                <a:latin typeface="Aptos" panose="02110004020202020204"/>
                                <a:ea typeface="Aptos" panose="020B0004020202020204" pitchFamily="34" charset="0"/>
                                <a:cs typeface="Times New Roman" panose="02020603050405020304" pitchFamily="18" charset="0"/>
                              </a:endParaRPr>
                            </a:p>
                            <a:p>
                              <a:pPr marL="0" marR="0" lvl="0" indent="0" algn="ctr" defTabSz="914400" eaLnBrk="1" fontAlgn="auto" latinLnBrk="0" hangingPunct="1">
                                <a:lnSpc>
                                  <a:spcPct val="115000"/>
                                </a:lnSpc>
                                <a:spcBef>
                                  <a:spcPts val="0"/>
                                </a:spcBef>
                                <a:spcAft>
                                  <a:spcPts val="800"/>
                                </a:spcAft>
                                <a:buClrTx/>
                                <a:buSzTx/>
                                <a:buFontTx/>
                                <a:buNone/>
                                <a:tabLst/>
                                <a:defRPr/>
                              </a:pPr>
                              <a:r>
                                <a:rPr lang="en-US" sz="1200" b="1" kern="100" dirty="0">
                                  <a:solidFill>
                                    <a:sysClr val="window" lastClr="FFFFFF"/>
                                  </a:solidFill>
                                  <a:latin typeface="Times New Roman" panose="02020603050405020304" pitchFamily="18" charset="0"/>
                                  <a:ea typeface="Aptos" panose="020B0004020202020204" pitchFamily="34" charset="0"/>
                                  <a:cs typeface="Times New Roman" panose="02020603050405020304" pitchFamily="18" charset="0"/>
                                </a:rPr>
                                <a:t> </a:t>
                              </a:r>
                              <a:endParaRPr kumimoji="0" lang="en-US" sz="1200" b="0" i="0" u="none" strike="noStrike" kern="100" cap="none" spc="0" normalizeH="0" baseline="0" noProof="0" dirty="0">
                                <a:ln>
                                  <a:noFill/>
                                </a:ln>
                                <a:solidFill>
                                  <a:sysClr val="window" lastClr="FFFFFF"/>
                                </a:solidFill>
                                <a:effectLst/>
                                <a:uLnTx/>
                                <a:uFillTx/>
                                <a:latin typeface="Aptos" panose="02110004020202020204"/>
                                <a:ea typeface="Aptos" panose="020B0004020202020204" pitchFamily="34" charset="0"/>
                                <a:cs typeface="Times New Roman" panose="02020603050405020304" pitchFamily="18" charset="0"/>
                              </a:endParaRPr>
                            </a:p>
                          </p:txBody>
                        </p:sp>
                      </p:grpSp>
                    </p:grpSp>
                    <p:grpSp>
                      <p:nvGrpSpPr>
                        <p:cNvPr id="92" name="Group 91">
                          <a:extLst>
                            <a:ext uri="{FF2B5EF4-FFF2-40B4-BE49-F238E27FC236}">
                              <a16:creationId xmlns:a16="http://schemas.microsoft.com/office/drawing/2014/main" id="{EB46E691-41C0-A6BE-D4B3-1E0C80E65DD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335546" y="5974859"/>
                          <a:ext cx="3569342" cy="1258656"/>
                          <a:chOff x="5183822" y="9447724"/>
                          <a:chExt cx="3931825" cy="1773219"/>
                        </a:xfrm>
                      </p:grpSpPr>
                      <p:sp>
                        <p:nvSpPr>
                          <p:cNvPr id="97" name="Oval 96">
                            <a:extLst>
                              <a:ext uri="{FF2B5EF4-FFF2-40B4-BE49-F238E27FC236}">
                                <a16:creationId xmlns:a16="http://schemas.microsoft.com/office/drawing/2014/main" id="{6BC68EDA-A081-8DB8-AB40-77873E7B8CF9}"/>
                              </a:ext>
                            </a:extLst>
                          </p:cNvPr>
                          <p:cNvSpPr/>
                          <p:nvPr/>
                        </p:nvSpPr>
                        <p:spPr>
                          <a:xfrm>
                            <a:off x="6736514" y="9447724"/>
                            <a:ext cx="2379133" cy="1773219"/>
                          </a:xfrm>
                          <a:prstGeom prst="ellipse">
                            <a:avLst/>
                          </a:prstGeom>
                          <a:solidFill>
                            <a:srgbClr val="E97132"/>
                          </a:solidFill>
                          <a:ln w="12700" cap="flat" cmpd="sng" algn="ctr">
                            <a:noFill/>
                            <a:prstDash val="solid"/>
                            <a:miter lim="800000"/>
                          </a:ln>
                          <a:effectLst/>
                        </p:spPr>
                        <p:txBody>
                          <a:bodyPr rot="0" spcFirstLastPara="0" vert="horz" wrap="square" lIns="91440" tIns="45720" rIns="91440" bIns="45720" numCol="1" spcCol="0" rtlCol="0" fromWordArt="0" anchor="ctr" anchorCtr="0" forceAA="0" compatLnSpc="1">
                            <a:prstTxWarp prst="textNoShape">
                              <a:avLst/>
                            </a:prstTxWarp>
                            <a:noAutofit/>
                          </a:bodyPr>
                          <a:lstStyle/>
                          <a:p>
                            <a:pPr marL="0" marR="0" lvl="0" indent="0" algn="ctr" defTabSz="914400" eaLnBrk="1" fontAlgn="auto" latinLnBrk="0" hangingPunct="1">
                              <a:lnSpc>
                                <a:spcPct val="115000"/>
                              </a:lnSpc>
                              <a:spcBef>
                                <a:spcPts val="0"/>
                              </a:spcBef>
                              <a:spcAft>
                                <a:spcPts val="800"/>
                              </a:spcAft>
                              <a:buClrTx/>
                              <a:buSzTx/>
                              <a:buFontTx/>
                              <a:buNone/>
                              <a:tabLst/>
                              <a:defRPr/>
                            </a:pPr>
                            <a:r>
                              <a:rPr lang="en-US" sz="1200" b="1" kern="100" dirty="0">
                                <a:solidFill>
                                  <a:sysClr val="window" lastClr="FFFFFF"/>
                                </a:solidFill>
                                <a:latin typeface="Times New Roman" panose="02020603050405020304" pitchFamily="18" charset="0"/>
                                <a:ea typeface="Aptos" panose="020B0004020202020204" pitchFamily="34" charset="0"/>
                                <a:cs typeface="Times New Roman" panose="02020603050405020304" pitchFamily="18" charset="0"/>
                              </a:rPr>
                              <a:t>GSEA Enrichment Analysis  </a:t>
                            </a:r>
                            <a:endParaRPr kumimoji="0" lang="en-US" sz="1200" b="0" i="0" u="none" strike="noStrike" kern="100" cap="none" spc="0" normalizeH="0" baseline="0" noProof="0" dirty="0">
                              <a:ln>
                                <a:noFill/>
                              </a:ln>
                              <a:solidFill>
                                <a:sysClr val="window" lastClr="FFFFFF"/>
                              </a:solidFill>
                              <a:effectLst/>
                              <a:uLnTx/>
                              <a:uFillTx/>
                              <a:latin typeface="Aptos" panose="02110004020202020204"/>
                              <a:ea typeface="Aptos" panose="020B0004020202020204" pitchFamily="34" charset="0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cxnSp>
                        <p:nvCxnSpPr>
                          <p:cNvPr id="94" name="Connector: Curved 93">
                            <a:extLst>
                              <a:ext uri="{FF2B5EF4-FFF2-40B4-BE49-F238E27FC236}">
                                <a16:creationId xmlns:a16="http://schemas.microsoft.com/office/drawing/2014/main" id="{24AA8459-0426-30FE-140E-7C33971F5387}"/>
                              </a:ext>
                            </a:extLst>
                          </p:cNvPr>
                          <p:cNvCxnSpPr>
                            <a:cxnSpLocks/>
                            <a:stCxn id="47" idx="4"/>
                            <a:endCxn id="97" idx="2"/>
                          </p:cNvCxnSpPr>
                          <p:nvPr/>
                        </p:nvCxnSpPr>
                        <p:spPr>
                          <a:xfrm rot="16200000" flipH="1">
                            <a:off x="5823377" y="9421197"/>
                            <a:ext cx="273582" cy="1552691"/>
                          </a:xfrm>
                          <a:prstGeom prst="curvedConnector2">
                            <a:avLst/>
                          </a:prstGeom>
                          <a:noFill/>
                          <a:ln w="6350" cap="flat" cmpd="sng" algn="ctr">
                            <a:solidFill>
                              <a:srgbClr val="E97132"/>
                            </a:solidFill>
                            <a:prstDash val="solid"/>
                            <a:miter lim="800000"/>
                            <a:tailEnd type="triangle"/>
                          </a:ln>
                          <a:effectLst/>
                        </p:spPr>
                      </p:cxnSp>
                    </p:grpSp>
                  </p:grpSp>
                </p:grpSp>
                <p:sp>
                  <p:nvSpPr>
                    <p:cNvPr id="106" name="Rectangle: Rounded Corners 105">
                      <a:extLst>
                        <a:ext uri="{FF2B5EF4-FFF2-40B4-BE49-F238E27FC236}">
                          <a16:creationId xmlns:a16="http://schemas.microsoft.com/office/drawing/2014/main" id="{E509FB0C-25FE-46DB-F4E3-623190C4748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218773" y="829407"/>
                      <a:ext cx="1099443" cy="216427"/>
                    </a:xfrm>
                    <a:prstGeom prst="roundRect">
                      <a:avLst/>
                    </a:prstGeom>
                    <a:noFill/>
                    <a:ln w="12700" cap="flat" cmpd="sng" algn="ctr">
                      <a:noFill/>
                      <a:prstDash val="solid"/>
                      <a:miter lim="800000"/>
                    </a:ln>
                    <a:effectLst/>
                  </p:spPr>
                  <p:txBody>
                    <a:bodyPr rot="0" spcFirstLastPara="0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marL="0" marR="0" lvl="0" indent="228600" defTabSz="914400" eaLnBrk="1" fontAlgn="auto" latinLnBrk="0" hangingPunct="1"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1" i="0" u="none" strike="noStrike" kern="100" cap="none" spc="0" normalizeH="0" baseline="0" noProof="0" dirty="0" err="1">
                          <a:ln>
                            <a:noFill/>
                          </a:ln>
                          <a:solidFill>
                            <a:srgbClr val="156082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ldsc</a:t>
                      </a:r>
                      <a:endParaRPr kumimoji="0" lang="en-US" sz="1200" b="0" i="0" u="none" strike="noStrike" kern="100" cap="none" spc="0" normalizeH="0" baseline="0" noProof="0" dirty="0">
                        <a:ln>
                          <a:noFill/>
                        </a:ln>
                        <a:solidFill>
                          <a:sysClr val="window" lastClr="FFFFFF"/>
                        </a:solidFill>
                        <a:effectLst/>
                        <a:uLnTx/>
                        <a:uFillTx/>
                        <a:latin typeface="Aptos" panose="02110004020202020204"/>
                        <a:ea typeface="Aptos" panose="020B000402020202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cxnSp>
                <p:nvCxnSpPr>
                  <p:cNvPr id="89" name="Connector: Curved 88">
                    <a:extLst>
                      <a:ext uri="{FF2B5EF4-FFF2-40B4-BE49-F238E27FC236}">
                        <a16:creationId xmlns:a16="http://schemas.microsoft.com/office/drawing/2014/main" id="{B72BBE2C-D8FB-2FCE-7D7E-76FC3D78B0C4}"/>
                      </a:ext>
                    </a:extLst>
                  </p:cNvPr>
                  <p:cNvCxnSpPr>
                    <a:cxnSpLocks/>
                    <a:stCxn id="65" idx="3"/>
                    <a:endCxn id="53" idx="2"/>
                  </p:cNvCxnSpPr>
                  <p:nvPr/>
                </p:nvCxnSpPr>
                <p:spPr>
                  <a:xfrm rot="16200000" flipH="1">
                    <a:off x="1216643" y="919553"/>
                    <a:ext cx="451459" cy="478010"/>
                  </a:xfrm>
                  <a:prstGeom prst="curvedConnector2">
                    <a:avLst/>
                  </a:prstGeom>
                  <a:noFill/>
                  <a:ln w="6350" cap="flat" cmpd="sng" algn="ctr">
                    <a:solidFill>
                      <a:srgbClr val="E97132"/>
                    </a:solidFill>
                    <a:prstDash val="solid"/>
                    <a:miter lim="800000"/>
                    <a:tailEnd type="triangle"/>
                  </a:ln>
                  <a:effectLst/>
                </p:spPr>
              </p:cxnSp>
            </p:grpSp>
            <p:sp>
              <p:nvSpPr>
                <p:cNvPr id="152" name="Rectangle: Rounded Corners 151">
                  <a:extLst>
                    <a:ext uri="{FF2B5EF4-FFF2-40B4-BE49-F238E27FC236}">
                      <a16:creationId xmlns:a16="http://schemas.microsoft.com/office/drawing/2014/main" id="{780AF68C-405F-6F15-82D6-01E1ED4E1F33}"/>
                    </a:ext>
                  </a:extLst>
                </p:cNvPr>
                <p:cNvSpPr/>
                <p:nvPr/>
              </p:nvSpPr>
              <p:spPr>
                <a:xfrm>
                  <a:off x="10345124" y="2325615"/>
                  <a:ext cx="1319052" cy="580774"/>
                </a:xfrm>
                <a:prstGeom prst="roundRect">
                  <a:avLst/>
                </a:prstGeom>
                <a:noFill/>
                <a:ln w="12700" cap="flat" cmpd="sng" algn="ctr">
                  <a:noFill/>
                  <a:prstDash val="solid"/>
                  <a:miter lim="800000"/>
                </a:ln>
                <a:effectLst/>
              </p:spPr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marL="0" marR="0" lvl="0" indent="228600" defTabSz="914400" eaLnBrk="1" fontAlgn="auto" latinLnBrk="0" hangingPunct="1">
                    <a:lnSpc>
                      <a:spcPct val="115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800" b="1" kern="100" dirty="0">
                      <a:solidFill>
                        <a:srgbClr val="156082"/>
                      </a:solidFill>
                      <a:latin typeface="Times New Roman" panose="02020603050405020304" pitchFamily="18" charset="0"/>
                      <a:ea typeface="Aptos" panose="020B0004020202020204" pitchFamily="34" charset="0"/>
                      <a:cs typeface="Times New Roman" panose="02020603050405020304" pitchFamily="18" charset="0"/>
                    </a:rPr>
                    <a:t>Forward FSMR </a:t>
                  </a:r>
                  <a:endParaRPr kumimoji="0" lang="en-US" sz="12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" lastClr="FFFFFF"/>
                    </a:solidFill>
                    <a:effectLst/>
                    <a:uLnTx/>
                    <a:uFillTx/>
                    <a:latin typeface="Aptos" panose="02110004020202020204"/>
                    <a:ea typeface="Aptos" panose="020B0004020202020204" pitchFamily="34" charset="0"/>
                    <a:cs typeface="Times New Roman" panose="02020603050405020304" pitchFamily="18" charset="0"/>
                  </a:endParaRPr>
                </a:p>
                <a:p>
                  <a:pPr marL="0" marR="0" lvl="0" indent="228600" defTabSz="914400" eaLnBrk="1" fontAlgn="auto" latinLnBrk="0" hangingPunct="1">
                    <a:lnSpc>
                      <a:spcPct val="115000"/>
                    </a:lnSpc>
                    <a:spcBef>
                      <a:spcPts val="0"/>
                    </a:spcBef>
                    <a:spcAft>
                      <a:spcPts val="80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sz="800" b="1" kern="100" dirty="0">
                      <a:solidFill>
                        <a:srgbClr val="156082"/>
                      </a:solidFill>
                      <a:latin typeface="Times New Roman" panose="02020603050405020304" pitchFamily="18" charset="0"/>
                      <a:ea typeface="Aptos" panose="020B0004020202020204" pitchFamily="34" charset="0"/>
                      <a:cs typeface="Times New Roman" panose="02020603050405020304" pitchFamily="18" charset="0"/>
                    </a:rPr>
                    <a:t>Reverse GSMR</a:t>
                  </a:r>
                  <a:endParaRPr kumimoji="0" lang="en-US" sz="1200" b="0" i="0" u="none" strike="noStrike" kern="100" cap="none" spc="0" normalizeH="0" baseline="0" noProof="0" dirty="0">
                    <a:ln>
                      <a:noFill/>
                    </a:ln>
                    <a:solidFill>
                      <a:sysClr val="window" lastClr="FFFFFF"/>
                    </a:solidFill>
                    <a:effectLst/>
                    <a:uLnTx/>
                    <a:uFillTx/>
                    <a:latin typeface="Aptos" panose="02110004020202020204"/>
                    <a:ea typeface="Aptos" panose="020B0004020202020204" pitchFamily="34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64" name="Connector: Elbow 163">
                <a:extLst>
                  <a:ext uri="{FF2B5EF4-FFF2-40B4-BE49-F238E27FC236}">
                    <a16:creationId xmlns:a16="http://schemas.microsoft.com/office/drawing/2014/main" id="{28816864-D421-8A68-834D-6E31168003F4}"/>
                  </a:ext>
                </a:extLst>
              </p:cNvPr>
              <p:cNvCxnSpPr>
                <a:cxnSpLocks/>
                <a:stCxn id="82" idx="0"/>
              </p:cNvCxnSpPr>
              <p:nvPr/>
            </p:nvCxnSpPr>
            <p:spPr>
              <a:xfrm rot="5400000" flipH="1" flipV="1">
                <a:off x="6785487" y="2841127"/>
                <a:ext cx="361575" cy="414797"/>
              </a:xfrm>
              <a:prstGeom prst="bentConnector2">
                <a:avLst/>
              </a:prstGeom>
              <a:noFill/>
              <a:ln w="6350" cap="flat" cmpd="sng" algn="ctr">
                <a:solidFill>
                  <a:srgbClr val="156082"/>
                </a:solidFill>
                <a:prstDash val="solid"/>
                <a:miter lim="800000"/>
                <a:tailEnd type="triangle"/>
              </a:ln>
              <a:effectLst/>
            </p:spPr>
          </p:cxnSp>
        </p:grpSp>
        <p:sp>
          <p:nvSpPr>
            <p:cNvPr id="174" name="Rectangle: Rounded Corners 173">
              <a:extLst>
                <a:ext uri="{FF2B5EF4-FFF2-40B4-BE49-F238E27FC236}">
                  <a16:creationId xmlns:a16="http://schemas.microsoft.com/office/drawing/2014/main" id="{D0C3A0B9-10F4-AE6F-4B82-49C37775AA86}"/>
                </a:ext>
              </a:extLst>
            </p:cNvPr>
            <p:cNvSpPr/>
            <p:nvPr/>
          </p:nvSpPr>
          <p:spPr>
            <a:xfrm>
              <a:off x="7172840" y="2460401"/>
              <a:ext cx="1041465" cy="603775"/>
            </a:xfrm>
            <a:prstGeom prst="roundRect">
              <a:avLst/>
            </a:prstGeom>
            <a:noFill/>
            <a:ln w="12700" cap="flat" cmpd="sng" algn="ctr">
              <a:noFill/>
              <a:prstDash val="solid"/>
              <a:miter lim="800000"/>
            </a:ln>
            <a:effectLst/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228600" defTabSz="914400" eaLnBrk="1" fontAlgn="auto" latinLnBrk="0" hangingPunct="1">
                <a:lnSpc>
                  <a:spcPct val="115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00" cap="none" spc="0" normalizeH="0" baseline="0" noProof="0" dirty="0">
                  <a:ln>
                    <a:noFill/>
                  </a:ln>
                  <a:solidFill>
                    <a:srgbClr val="156082"/>
                  </a:solidFill>
                  <a:effectLst/>
                  <a:uLnTx/>
                  <a:uFillTx/>
                  <a:latin typeface="Times New Roman" panose="02020603050405020304" pitchFamily="18" charset="0"/>
                  <a:ea typeface="Aptos" panose="020B0004020202020204" pitchFamily="34" charset="0"/>
                  <a:cs typeface="Times New Roman" panose="02020603050405020304" pitchFamily="18" charset="0"/>
                </a:rPr>
                <a:t> </a:t>
              </a:r>
              <a:r>
                <a:rPr kumimoji="0" lang="en-US" sz="800" b="1" i="0" u="none" strike="noStrike" kern="100" cap="none" spc="0" normalizeH="0" baseline="0" noProof="0" dirty="0" err="1">
                  <a:ln>
                    <a:noFill/>
                  </a:ln>
                  <a:solidFill>
                    <a:srgbClr val="156082"/>
                  </a:solidFill>
                  <a:effectLst/>
                  <a:uLnTx/>
                  <a:uFillTx/>
                  <a:latin typeface="Times New Roman" panose="02020603050405020304" pitchFamily="18" charset="0"/>
                  <a:ea typeface="Aptos" panose="020B0004020202020204" pitchFamily="34" charset="0"/>
                  <a:cs typeface="Times New Roman" panose="02020603050405020304" pitchFamily="18" charset="0"/>
                </a:rPr>
                <a:t>Coloc,SUSIE</a:t>
              </a:r>
              <a:r>
                <a:rPr kumimoji="0" lang="en-US" sz="800" b="1" i="0" u="none" strike="noStrike" kern="100" cap="none" spc="0" normalizeH="0" baseline="0" noProof="0" dirty="0">
                  <a:ln>
                    <a:noFill/>
                  </a:ln>
                  <a:solidFill>
                    <a:srgbClr val="156082"/>
                  </a:solidFill>
                  <a:effectLst/>
                  <a:uLnTx/>
                  <a:uFillTx/>
                  <a:latin typeface="Times New Roman" panose="02020603050405020304" pitchFamily="18" charset="0"/>
                  <a:ea typeface="Aptos" panose="020B0004020202020204" pitchFamily="34" charset="0"/>
                  <a:cs typeface="Times New Roman" panose="02020603050405020304" pitchFamily="18" charset="0"/>
                </a:rPr>
                <a:t> </a:t>
              </a:r>
              <a:endParaRPr kumimoji="0" lang="en-US" sz="1200" b="0" i="0" u="none" strike="noStrike" kern="100" cap="none" spc="0" normalizeH="0" baseline="0" noProof="0" dirty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Aptos" panose="02110004020202020204"/>
                <a:ea typeface="Aptos" panose="020B000402020202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01901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4EDEEAB-63EA-FD34-E0DD-401E810AFE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554" y="0"/>
            <a:ext cx="4484906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1933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DB873030-BFC0-58FA-1134-D81F7FBB24D6}"/>
              </a:ext>
            </a:extLst>
          </p:cNvPr>
          <p:cNvGrpSpPr/>
          <p:nvPr/>
        </p:nvGrpSpPr>
        <p:grpSpPr>
          <a:xfrm>
            <a:off x="1557215" y="552375"/>
            <a:ext cx="8268956" cy="5383967"/>
            <a:chOff x="0" y="0"/>
            <a:chExt cx="4525645" cy="2651760"/>
          </a:xfrm>
        </p:grpSpPr>
        <p:pic>
          <p:nvPicPr>
            <p:cNvPr id="15" name="Picture 14" descr="A group of graphs showing different colored dots">
              <a:extLst>
                <a:ext uri="{FF2B5EF4-FFF2-40B4-BE49-F238E27FC236}">
                  <a16:creationId xmlns:a16="http://schemas.microsoft.com/office/drawing/2014/main" id="{905584A3-05CD-1D11-F7DB-679B907364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4525645" cy="265176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6" name="Text Box 8">
              <a:extLst>
                <a:ext uri="{FF2B5EF4-FFF2-40B4-BE49-F238E27FC236}">
                  <a16:creationId xmlns:a16="http://schemas.microsoft.com/office/drawing/2014/main" id="{E0375007-CC1A-C507-20FB-DF93A0DB9D31}"/>
                </a:ext>
              </a:extLst>
            </p:cNvPr>
            <p:cNvSpPr txBox="1"/>
            <p:nvPr/>
          </p:nvSpPr>
          <p:spPr>
            <a:xfrm>
              <a:off x="158496" y="2353056"/>
              <a:ext cx="307975" cy="295275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15000"/>
                </a:lnSpc>
                <a:spcAft>
                  <a:spcPts val="800"/>
                </a:spcAft>
              </a:pPr>
              <a:r>
                <a:rPr lang="en-US" sz="1200" kern="100" dirty="0">
                  <a:effectLst/>
                  <a:latin typeface="Aptos" panose="020B0004020202020204" pitchFamily="34" charset="0"/>
                  <a:ea typeface="Aptos" panose="020B0004020202020204" pitchFamily="34" charset="0"/>
                  <a:cs typeface="Times New Roman" panose="02020603050405020304" pitchFamily="18" charset="0"/>
                </a:rPr>
                <a:t>A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362822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graphs showing different colored dots">
            <a:extLst>
              <a:ext uri="{FF2B5EF4-FFF2-40B4-BE49-F238E27FC236}">
                <a16:creationId xmlns:a16="http://schemas.microsoft.com/office/drawing/2014/main" id="{A3BC7D55-7168-100D-DCFF-0319B5B7432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6928" y="954730"/>
            <a:ext cx="8443672" cy="494853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295598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group of images of different colored dots">
            <a:extLst>
              <a:ext uri="{FF2B5EF4-FFF2-40B4-BE49-F238E27FC236}">
                <a16:creationId xmlns:a16="http://schemas.microsoft.com/office/drawing/2014/main" id="{ECD22761-84E1-F750-E2DC-88AD3BDC6B7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7344" y="827314"/>
            <a:ext cx="9614728" cy="563485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647395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 descr="A pie chart with different colored circles&#10;&#10;Description automatically generated">
            <a:extLst>
              <a:ext uri="{FF2B5EF4-FFF2-40B4-BE49-F238E27FC236}">
                <a16:creationId xmlns:a16="http://schemas.microsoft.com/office/drawing/2014/main" id="{CFF1C7EC-7351-C6AE-FB2A-FEE5C0696C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9527" y="643466"/>
            <a:ext cx="9992945" cy="5571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00625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B019F9F-B850-9F0E-83CE-F23B43A011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083" y="542307"/>
            <a:ext cx="4077188" cy="54032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29490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F9921DA-AB6F-D8EF-B9E2-2BACFB7613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547" y="457200"/>
            <a:ext cx="4484906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86881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597E894F-6C6A-1500-2F27-56355F66B1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3547" y="457200"/>
            <a:ext cx="4484906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85057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0784C57-D84E-E785-E9DE-A1BA6C8AE4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8554" y="0"/>
            <a:ext cx="4484906" cy="5943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FF91A0C-348E-BFFF-D946-997902C5A1F8}"/>
              </a:ext>
            </a:extLst>
          </p:cNvPr>
          <p:cNvSpPr txBox="1"/>
          <p:nvPr/>
        </p:nvSpPr>
        <p:spPr>
          <a:xfrm>
            <a:off x="1701210" y="1778813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SAS</a:t>
            </a:r>
          </a:p>
        </p:txBody>
      </p:sp>
    </p:spTree>
    <p:extLst>
      <p:ext uri="{BB962C8B-B14F-4D97-AF65-F5344CB8AC3E}">
        <p14:creationId xmlns:p14="http://schemas.microsoft.com/office/powerpoint/2010/main" val="25658564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22</TotalTime>
  <Words>217</Words>
  <Application>Microsoft Office PowerPoint</Application>
  <PresentationFormat>Widescreen</PresentationFormat>
  <Paragraphs>51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i, Muhammad Sarfraz (sfj2zp)</dc:creator>
  <cp:lastModifiedBy>Ali, Muhammad Sarfraz (sfj2zp)</cp:lastModifiedBy>
  <cp:revision>53</cp:revision>
  <dcterms:created xsi:type="dcterms:W3CDTF">2025-09-29T17:22:16Z</dcterms:created>
  <dcterms:modified xsi:type="dcterms:W3CDTF">2026-05-04T23:50:04Z</dcterms:modified>
</cp:coreProperties>
</file>